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49496-2676-4D0A-ACA8-74109B34C02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19EDAA-4E86-461C-940F-0CA6608694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57F957-5E74-4D86-919C-913AE9D05B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5B9C8F-8625-424F-A71E-D31A56A2EE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3BE582-B811-4136-8FE6-8DF585C4EF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A9C6DD-0941-4AA5-93EC-B5A20E304D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C73C6C-B697-4953-B689-87B7BFE78C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BC6A0-A5AA-44E0-A5D0-B5FF8F6919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659C7D-2812-4C3A-8DD5-81FA601DA8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967B82-A494-4134-A200-0DEFF22067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9BE4E-F249-4318-91F8-EE6C50EAA8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7DC39-24CB-45BB-8520-7CA9F33F13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FCA168-659C-4041-BF33-F1719141C17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243080" y="250920"/>
            <a:ext cx="169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428640" y="4338720"/>
            <a:ext cx="1850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04640" y="4338720"/>
            <a:ext cx="169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557360" y="4299120"/>
            <a:ext cx="3297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459320" y="4299120"/>
            <a:ext cx="4824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H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244600" y="517680"/>
            <a:ext cx="1506600" cy="307800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244600" y="3494160"/>
            <a:ext cx="3016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e6d600"/>
          </a:solidFill>
          <a:ln w="9360">
            <a:solidFill>
              <a:srgbClr val="e6d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546280" y="3494160"/>
            <a:ext cx="301680" cy="1015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e69900"/>
          </a:solidFill>
          <a:ln w="9360">
            <a:solidFill>
              <a:srgbClr val="e699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847960" y="349416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e67a00"/>
          </a:solidFill>
          <a:ln w="9360">
            <a:solidFill>
              <a:srgbClr val="e67a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147840" y="3494160"/>
            <a:ext cx="3034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e65800"/>
          </a:solidFill>
          <a:ln w="9360">
            <a:solidFill>
              <a:srgbClr val="e658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451320" y="349416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e65f00"/>
          </a:solidFill>
          <a:ln w="9360">
            <a:solidFill>
              <a:srgbClr val="e65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244600" y="3390840"/>
            <a:ext cx="3016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9de600"/>
          </a:solidFill>
          <a:ln w="9360">
            <a:solidFill>
              <a:srgbClr val="9d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546280" y="3390840"/>
            <a:ext cx="301680" cy="10332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c7e600"/>
          </a:solidFill>
          <a:ln w="9360">
            <a:solidFill>
              <a:srgbClr val="c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847960" y="3390840"/>
            <a:ext cx="2998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a8e600"/>
          </a:solidFill>
          <a:ln w="9360">
            <a:solidFill>
              <a:srgbClr val="a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147840" y="3390840"/>
            <a:ext cx="3034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82e600"/>
          </a:solidFill>
          <a:ln w="9360">
            <a:solidFill>
              <a:srgbClr val="82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451320" y="3390840"/>
            <a:ext cx="2998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a1e600"/>
          </a:solidFill>
          <a:ln w="9360">
            <a:solidFill>
              <a:srgbClr val="a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244600" y="3287880"/>
            <a:ext cx="3016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e6e600"/>
          </a:solidFill>
          <a:ln w="9360">
            <a:solidFill>
              <a:srgbClr val="e6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546280" y="3287880"/>
            <a:ext cx="301680" cy="10296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99e600"/>
          </a:solidFill>
          <a:ln w="9360">
            <a:solidFill>
              <a:srgbClr val="99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847960" y="3287880"/>
            <a:ext cx="2998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9de600"/>
          </a:solidFill>
          <a:ln w="9360">
            <a:solidFill>
              <a:srgbClr val="9d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147840" y="3287880"/>
            <a:ext cx="3034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8ae600"/>
          </a:solidFill>
          <a:ln w="9360">
            <a:solidFill>
              <a:srgbClr val="8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451320" y="3287880"/>
            <a:ext cx="2998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8ae600"/>
          </a:solidFill>
          <a:ln w="9360">
            <a:solidFill>
              <a:srgbClr val="8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244600" y="3186000"/>
            <a:ext cx="301680" cy="10188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a8e600"/>
          </a:solidFill>
          <a:ln w="9360">
            <a:solidFill>
              <a:srgbClr val="a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546280" y="3186000"/>
            <a:ext cx="301680" cy="10188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63e600"/>
          </a:solidFill>
          <a:ln w="9360">
            <a:solidFill>
              <a:srgbClr val="6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847960" y="3186000"/>
            <a:ext cx="299880" cy="10188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b4e600"/>
          </a:solidFill>
          <a:ln w="9360">
            <a:solidFill>
              <a:srgbClr val="b4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147840" y="3186000"/>
            <a:ext cx="303480" cy="10188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73e600"/>
          </a:solidFill>
          <a:ln w="9360">
            <a:solidFill>
              <a:srgbClr val="7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451320" y="3186000"/>
            <a:ext cx="299880" cy="10188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8ae600"/>
          </a:solidFill>
          <a:ln w="9360">
            <a:solidFill>
              <a:srgbClr val="8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244600" y="3083040"/>
            <a:ext cx="3016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cbe600"/>
          </a:solidFill>
          <a:ln w="9360">
            <a:solidFill>
              <a:srgbClr val="cb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546280" y="3083040"/>
            <a:ext cx="301680" cy="10296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17e600"/>
          </a:solidFill>
          <a:ln w="9360">
            <a:solidFill>
              <a:srgbClr val="1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847960" y="3083040"/>
            <a:ext cx="2998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82e600"/>
          </a:solidFill>
          <a:ln w="9360">
            <a:solidFill>
              <a:srgbClr val="82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147840" y="3083040"/>
            <a:ext cx="3034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ace600"/>
          </a:solidFill>
          <a:ln w="9360">
            <a:solidFill>
              <a:srgbClr val="ac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451320" y="3083040"/>
            <a:ext cx="2998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e6e200"/>
          </a:solidFill>
          <a:ln w="9360">
            <a:solidFill>
              <a:srgbClr val="e6e2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244600" y="2979720"/>
            <a:ext cx="3016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7ee600"/>
          </a:solidFill>
          <a:ln w="9360">
            <a:solidFill>
              <a:srgbClr val="7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546280" y="2979720"/>
            <a:ext cx="301680" cy="10332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82e600"/>
          </a:solidFill>
          <a:ln w="9360">
            <a:solidFill>
              <a:srgbClr val="82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847960" y="2979720"/>
            <a:ext cx="2998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63e600"/>
          </a:solidFill>
          <a:ln w="9360">
            <a:solidFill>
              <a:srgbClr val="6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147840" y="2979720"/>
            <a:ext cx="3034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e6b400"/>
          </a:solidFill>
          <a:ln w="9360">
            <a:solidFill>
              <a:srgbClr val="e6b4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451320" y="2979720"/>
            <a:ext cx="2998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e65f00"/>
          </a:solidFill>
          <a:ln w="9360">
            <a:solidFill>
              <a:srgbClr val="e65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244600" y="2878200"/>
            <a:ext cx="3016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17e600"/>
          </a:solidFill>
          <a:ln w="9360">
            <a:solidFill>
              <a:srgbClr val="1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546280" y="2878200"/>
            <a:ext cx="301680" cy="1015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76e600"/>
          </a:solidFill>
          <a:ln w="9360">
            <a:solidFill>
              <a:srgbClr val="76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847960" y="287820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44e600"/>
          </a:solidFill>
          <a:ln w="9360">
            <a:solidFill>
              <a:srgbClr val="44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147840" y="2878200"/>
            <a:ext cx="3034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e6da00"/>
          </a:solidFill>
          <a:ln w="9360">
            <a:solidFill>
              <a:srgbClr val="e6da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451320" y="287820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b7e600"/>
          </a:solidFill>
          <a:ln w="9360">
            <a:solidFill>
              <a:srgbClr val="b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244600" y="2774880"/>
            <a:ext cx="3016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50"/>
          </a:solidFill>
          <a:ln w="9360">
            <a:solidFill>
              <a:srgbClr val="00e65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546280" y="2774880"/>
            <a:ext cx="301680" cy="1033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22e600"/>
          </a:solidFill>
          <a:ln w="9360">
            <a:solidFill>
              <a:srgbClr val="22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847960" y="277488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58e600"/>
          </a:solidFill>
          <a:ln w="9360">
            <a:solidFill>
              <a:srgbClr val="5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147840" y="2774880"/>
            <a:ext cx="3034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a1e600"/>
          </a:solidFill>
          <a:ln w="9360">
            <a:solidFill>
              <a:srgbClr val="a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451320" y="277488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d6e600"/>
          </a:solidFill>
          <a:ln w="9360">
            <a:solidFill>
              <a:srgbClr val="d6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244600" y="2671920"/>
            <a:ext cx="3016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de"/>
          </a:solidFill>
          <a:ln w="9360">
            <a:solidFill>
              <a:srgbClr val="00e6d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546280" y="2671920"/>
            <a:ext cx="301680" cy="10296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31e600"/>
          </a:solidFill>
          <a:ln w="9360">
            <a:solidFill>
              <a:srgbClr val="3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847960" y="2671920"/>
            <a:ext cx="2998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99e600"/>
          </a:solidFill>
          <a:ln w="9360">
            <a:solidFill>
              <a:srgbClr val="99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147840" y="2671920"/>
            <a:ext cx="3034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dae600"/>
          </a:solidFill>
          <a:ln w="9360">
            <a:solidFill>
              <a:srgbClr val="d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451320" y="2671920"/>
            <a:ext cx="2998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e6d200"/>
          </a:solidFill>
          <a:ln w="9360">
            <a:solidFill>
              <a:srgbClr val="e6d2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244600" y="2570040"/>
            <a:ext cx="301680" cy="10188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bf"/>
          </a:solidFill>
          <a:ln w="9360">
            <a:solidFill>
              <a:srgbClr val="00e6b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546280" y="2570040"/>
            <a:ext cx="301680" cy="10188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22"/>
          </a:solidFill>
          <a:ln w="9360">
            <a:solidFill>
              <a:srgbClr val="00e622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847960" y="2570040"/>
            <a:ext cx="299880" cy="10188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e6bf00"/>
          </a:solidFill>
          <a:ln w="9360">
            <a:solidFill>
              <a:srgbClr val="e6b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147840" y="2570040"/>
            <a:ext cx="303480" cy="10188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73e600"/>
          </a:solidFill>
          <a:ln w="9360">
            <a:solidFill>
              <a:srgbClr val="7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451320" y="2570040"/>
            <a:ext cx="299880" cy="10188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91e600"/>
          </a:solidFill>
          <a:ln w="9360">
            <a:solidFill>
              <a:srgbClr val="9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244600" y="2467080"/>
            <a:ext cx="3016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4ce600"/>
          </a:solidFill>
          <a:ln w="9360">
            <a:solidFill>
              <a:srgbClr val="4c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546280" y="2467080"/>
            <a:ext cx="301680" cy="10296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5be600"/>
          </a:solidFill>
          <a:ln w="9360">
            <a:solidFill>
              <a:srgbClr val="5b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2847960" y="2467080"/>
            <a:ext cx="2998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31e600"/>
          </a:solidFill>
          <a:ln w="9360">
            <a:solidFill>
              <a:srgbClr val="3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3147840" y="2467080"/>
            <a:ext cx="3034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41e600"/>
          </a:solidFill>
          <a:ln w="9360">
            <a:solidFill>
              <a:srgbClr val="4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451320" y="2467080"/>
            <a:ext cx="2998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48e600"/>
          </a:solidFill>
          <a:ln w="9360">
            <a:solidFill>
              <a:srgbClr val="4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244600" y="2365200"/>
            <a:ext cx="301680" cy="10188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39e600"/>
          </a:solidFill>
          <a:ln w="9360">
            <a:solidFill>
              <a:srgbClr val="39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546280" y="2365200"/>
            <a:ext cx="301680" cy="10188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26"/>
          </a:solidFill>
          <a:ln w="9360">
            <a:solidFill>
              <a:srgbClr val="00e62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847960" y="2365200"/>
            <a:ext cx="299880" cy="10188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17e600"/>
          </a:solidFill>
          <a:ln w="9360">
            <a:solidFill>
              <a:srgbClr val="1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147840" y="2365200"/>
            <a:ext cx="303480" cy="10188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82e600"/>
          </a:solidFill>
          <a:ln w="9360">
            <a:solidFill>
              <a:srgbClr val="82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451320" y="2365200"/>
            <a:ext cx="299880" cy="10188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63e600"/>
          </a:solidFill>
          <a:ln w="9360">
            <a:solidFill>
              <a:srgbClr val="6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244600" y="2262240"/>
            <a:ext cx="3016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03"/>
          </a:solidFill>
          <a:ln w="9360">
            <a:solidFill>
              <a:srgbClr val="00e60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546280" y="2262240"/>
            <a:ext cx="301680" cy="10296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13"/>
          </a:solidFill>
          <a:ln w="9360">
            <a:solidFill>
              <a:srgbClr val="00e61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847960" y="2262240"/>
            <a:ext cx="2998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a4e600"/>
          </a:solidFill>
          <a:ln w="9360">
            <a:solidFill>
              <a:srgbClr val="a4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147840" y="2262240"/>
            <a:ext cx="3034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2ae600"/>
          </a:solidFill>
          <a:ln w="9360">
            <a:solidFill>
              <a:srgbClr val="2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451320" y="2262240"/>
            <a:ext cx="2998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73e600"/>
          </a:solidFill>
          <a:ln w="9360">
            <a:solidFill>
              <a:srgbClr val="7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244600" y="2158920"/>
            <a:ext cx="3016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5f"/>
          </a:solidFill>
          <a:ln w="9360">
            <a:solidFill>
              <a:srgbClr val="00e65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2546280" y="2158920"/>
            <a:ext cx="301680" cy="1033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50"/>
          </a:solidFill>
          <a:ln w="9360">
            <a:solidFill>
              <a:srgbClr val="00e65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2847960" y="215892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0f"/>
          </a:solidFill>
          <a:ln w="9360">
            <a:solidFill>
              <a:srgbClr val="00e60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147840" y="2158920"/>
            <a:ext cx="3034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35e600"/>
          </a:solidFill>
          <a:ln w="9360">
            <a:solidFill>
              <a:srgbClr val="35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451320" y="215892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13e600"/>
          </a:solidFill>
          <a:ln w="9360">
            <a:solidFill>
              <a:srgbClr val="1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2244600" y="2057400"/>
            <a:ext cx="3016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2ee600"/>
          </a:solidFill>
          <a:ln w="9360">
            <a:solidFill>
              <a:srgbClr val="2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546280" y="2057400"/>
            <a:ext cx="301680" cy="1015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5f"/>
          </a:solidFill>
          <a:ln w="9360">
            <a:solidFill>
              <a:srgbClr val="00e65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847960" y="205740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44e600"/>
          </a:solidFill>
          <a:ln w="9360">
            <a:solidFill>
              <a:srgbClr val="44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147840" y="2057400"/>
            <a:ext cx="3034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13"/>
          </a:solidFill>
          <a:ln w="9360">
            <a:solidFill>
              <a:srgbClr val="00e61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451320" y="205740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50"/>
          </a:solidFill>
          <a:ln w="9360">
            <a:solidFill>
              <a:srgbClr val="00e65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244600" y="1954080"/>
            <a:ext cx="3016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95e600"/>
          </a:solidFill>
          <a:ln w="9360">
            <a:solidFill>
              <a:srgbClr val="95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2546280" y="1954080"/>
            <a:ext cx="301680" cy="10332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16"/>
          </a:solidFill>
          <a:ln w="9360">
            <a:solidFill>
              <a:srgbClr val="00e61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2847960" y="1954080"/>
            <a:ext cx="2998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b7"/>
          </a:solidFill>
          <a:ln w="9360">
            <a:solidFill>
              <a:srgbClr val="00e6b7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147840" y="1954080"/>
            <a:ext cx="3034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4c"/>
          </a:solidFill>
          <a:ln w="9360">
            <a:solidFill>
              <a:srgbClr val="00e64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451320" y="1954080"/>
            <a:ext cx="2998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39"/>
          </a:solidFill>
          <a:ln w="9360">
            <a:solidFill>
              <a:srgbClr val="00e63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244600" y="1852560"/>
            <a:ext cx="3016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c3e600"/>
          </a:solidFill>
          <a:ln w="9360">
            <a:solidFill>
              <a:srgbClr val="c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546280" y="1852560"/>
            <a:ext cx="301680" cy="1015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b4"/>
          </a:solidFill>
          <a:ln w="9360">
            <a:solidFill>
              <a:srgbClr val="00e6b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847960" y="185256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ac"/>
          </a:solidFill>
          <a:ln w="9360">
            <a:solidFill>
              <a:srgbClr val="00e6a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147840" y="1852560"/>
            <a:ext cx="3034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5c"/>
          </a:solidFill>
          <a:ln w="9360">
            <a:solidFill>
              <a:srgbClr val="00e65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451320" y="185256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5fe600"/>
          </a:solidFill>
          <a:ln w="9360">
            <a:solidFill>
              <a:srgbClr val="5f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2244600" y="1749600"/>
            <a:ext cx="3016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50e600"/>
          </a:solidFill>
          <a:ln w="9360">
            <a:solidFill>
              <a:srgbClr val="50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2546280" y="1749600"/>
            <a:ext cx="301680" cy="10296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2e"/>
          </a:solidFill>
          <a:ln w="9360">
            <a:solidFill>
              <a:srgbClr val="00e62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847960" y="1749600"/>
            <a:ext cx="2998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3d"/>
          </a:solidFill>
          <a:ln w="9360">
            <a:solidFill>
              <a:srgbClr val="00e63d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147840" y="1749600"/>
            <a:ext cx="3034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31"/>
          </a:solidFill>
          <a:ln w="9360">
            <a:solidFill>
              <a:srgbClr val="00e63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3451320" y="1749600"/>
            <a:ext cx="2998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c3e600"/>
          </a:solidFill>
          <a:ln w="9360">
            <a:solidFill>
              <a:srgbClr val="c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244600" y="1646280"/>
            <a:ext cx="3016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00"/>
          </a:solidFill>
          <a:ln w="9360">
            <a:solidFill>
              <a:srgbClr val="00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546280" y="1646280"/>
            <a:ext cx="301680" cy="1033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a1e6"/>
          </a:solidFill>
          <a:ln w="9360">
            <a:solidFill>
              <a:srgbClr val="00a1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2847960" y="164628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6b"/>
          </a:solidFill>
          <a:ln w="9360">
            <a:solidFill>
              <a:srgbClr val="00e66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3147840" y="1646280"/>
            <a:ext cx="3034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31e600"/>
          </a:solidFill>
          <a:ln w="9360">
            <a:solidFill>
              <a:srgbClr val="3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451320" y="164628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c3e600"/>
          </a:solidFill>
          <a:ln w="9360">
            <a:solidFill>
              <a:srgbClr val="c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2244600" y="1542960"/>
            <a:ext cx="3016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17e600"/>
          </a:solidFill>
          <a:ln w="9360">
            <a:solidFill>
              <a:srgbClr val="1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546280" y="1542960"/>
            <a:ext cx="301680" cy="1033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cfe6"/>
          </a:solidFill>
          <a:ln w="9360">
            <a:solidFill>
              <a:srgbClr val="00cf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847960" y="154296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86e6"/>
          </a:solidFill>
          <a:ln w="9360">
            <a:solidFill>
              <a:srgbClr val="0086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3147840" y="1542960"/>
            <a:ext cx="3034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16"/>
          </a:solidFill>
          <a:ln w="9360">
            <a:solidFill>
              <a:srgbClr val="00e61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3451320" y="154296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44e600"/>
          </a:solidFill>
          <a:ln w="9360">
            <a:solidFill>
              <a:srgbClr val="44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244600" y="1441440"/>
            <a:ext cx="301680" cy="1015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39e600"/>
          </a:solidFill>
          <a:ln w="9360">
            <a:solidFill>
              <a:srgbClr val="39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546280" y="1441440"/>
            <a:ext cx="301680" cy="10152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b4e600"/>
          </a:solidFill>
          <a:ln w="9360">
            <a:solidFill>
              <a:srgbClr val="b4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847960" y="1441440"/>
            <a:ext cx="299880" cy="1015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91e6"/>
          </a:solidFill>
          <a:ln w="9360">
            <a:solidFill>
              <a:srgbClr val="0091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3147840" y="1441440"/>
            <a:ext cx="303480" cy="1015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a4e6"/>
          </a:solidFill>
          <a:ln w="9360">
            <a:solidFill>
              <a:srgbClr val="00a4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3451320" y="1441440"/>
            <a:ext cx="299880" cy="1015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a4"/>
          </a:solidFill>
          <a:ln w="9360">
            <a:solidFill>
              <a:srgbClr val="00e6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2244600" y="1339920"/>
            <a:ext cx="3016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13e600"/>
          </a:solidFill>
          <a:ln w="9360">
            <a:solidFill>
              <a:srgbClr val="1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2546280" y="1339920"/>
            <a:ext cx="301680" cy="1015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ace600"/>
          </a:solidFill>
          <a:ln w="9360">
            <a:solidFill>
              <a:srgbClr val="ac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847960" y="133992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b0"/>
          </a:solidFill>
          <a:ln w="9360">
            <a:solidFill>
              <a:srgbClr val="00e6b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3147840" y="1339920"/>
            <a:ext cx="3034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58"/>
          </a:solidFill>
          <a:ln w="9360">
            <a:solidFill>
              <a:srgbClr val="00e658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3451320" y="133992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58"/>
          </a:solidFill>
          <a:ln w="9360">
            <a:solidFill>
              <a:srgbClr val="00e658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2244600" y="1236600"/>
            <a:ext cx="3016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03"/>
          </a:solidFill>
          <a:ln w="9360">
            <a:solidFill>
              <a:srgbClr val="00e60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546280" y="1236600"/>
            <a:ext cx="301680" cy="10332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07"/>
          </a:solidFill>
          <a:ln w="9360">
            <a:solidFill>
              <a:srgbClr val="00e607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847960" y="1236600"/>
            <a:ext cx="2998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a8"/>
          </a:solidFill>
          <a:ln w="9360">
            <a:solidFill>
              <a:srgbClr val="00e6a8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147840" y="1236600"/>
            <a:ext cx="3034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7e"/>
          </a:solidFill>
          <a:ln w="9360">
            <a:solidFill>
              <a:srgbClr val="00e67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3451320" y="1236600"/>
            <a:ext cx="2998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b0"/>
          </a:solidFill>
          <a:ln w="9360">
            <a:solidFill>
              <a:srgbClr val="00e6b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244600" y="1133640"/>
            <a:ext cx="3016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3e600"/>
          </a:solidFill>
          <a:ln w="9360">
            <a:solidFill>
              <a:srgbClr val="0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546280" y="1133640"/>
            <a:ext cx="301680" cy="10296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3d"/>
          </a:solidFill>
          <a:ln w="9360">
            <a:solidFill>
              <a:srgbClr val="00e63d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847960" y="1133640"/>
            <a:ext cx="2998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5c"/>
          </a:solidFill>
          <a:ln w="9360">
            <a:solidFill>
              <a:srgbClr val="00e65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147840" y="1133640"/>
            <a:ext cx="3034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d6e6"/>
          </a:solidFill>
          <a:ln w="9360">
            <a:solidFill>
              <a:srgbClr val="00d6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3451320" y="1133640"/>
            <a:ext cx="299880" cy="10296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dee6"/>
          </a:solidFill>
          <a:ln w="9360">
            <a:solidFill>
              <a:srgbClr val="00de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2244600" y="1030320"/>
            <a:ext cx="3016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3e600"/>
          </a:solidFill>
          <a:ln w="9360">
            <a:solidFill>
              <a:srgbClr val="0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2546280" y="1030320"/>
            <a:ext cx="301680" cy="10332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41"/>
          </a:solidFill>
          <a:ln w="9360">
            <a:solidFill>
              <a:srgbClr val="00e64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847960" y="1030320"/>
            <a:ext cx="2998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50"/>
          </a:solidFill>
          <a:ln w="9360">
            <a:solidFill>
              <a:srgbClr val="00e65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3147840" y="1030320"/>
            <a:ext cx="3034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67"/>
          </a:solidFill>
          <a:ln w="9360">
            <a:solidFill>
              <a:srgbClr val="00e667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3451320" y="1030320"/>
            <a:ext cx="299880" cy="1033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00e6"/>
          </a:solidFill>
          <a:ln w="9360">
            <a:solidFill>
              <a:srgbClr val="0000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2244600" y="927000"/>
            <a:ext cx="3016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13e600"/>
          </a:solidFill>
          <a:ln w="9360">
            <a:solidFill>
              <a:srgbClr val="1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2546280" y="927000"/>
            <a:ext cx="301680" cy="1033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31"/>
          </a:solidFill>
          <a:ln w="9360">
            <a:solidFill>
              <a:srgbClr val="00e63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2847960" y="92700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67"/>
          </a:solidFill>
          <a:ln w="9360">
            <a:solidFill>
              <a:srgbClr val="00e667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3147840" y="927000"/>
            <a:ext cx="3034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b0"/>
          </a:solidFill>
          <a:ln w="9360">
            <a:solidFill>
              <a:srgbClr val="00e6b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3451320" y="92700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50e6"/>
          </a:solidFill>
          <a:ln w="9360">
            <a:solidFill>
              <a:srgbClr val="0050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2244600" y="825480"/>
            <a:ext cx="3016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0f"/>
          </a:solidFill>
          <a:ln w="9360">
            <a:solidFill>
              <a:srgbClr val="00e60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2546280" y="825480"/>
            <a:ext cx="301680" cy="1015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44"/>
          </a:solidFill>
          <a:ln w="9360">
            <a:solidFill>
              <a:srgbClr val="00e64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847960" y="82548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07"/>
          </a:solidFill>
          <a:ln w="9360">
            <a:solidFill>
              <a:srgbClr val="00e607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3147840" y="825480"/>
            <a:ext cx="3034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5fe6"/>
          </a:solidFill>
          <a:ln w="9360">
            <a:solidFill>
              <a:srgbClr val="005f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3451320" y="825480"/>
            <a:ext cx="299880" cy="1015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2ee6"/>
          </a:solidFill>
          <a:ln w="9360">
            <a:solidFill>
              <a:srgbClr val="002e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2244600" y="723960"/>
            <a:ext cx="301680" cy="1015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73e600"/>
          </a:solidFill>
          <a:ln w="9360">
            <a:solidFill>
              <a:srgbClr val="7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2546280" y="723960"/>
            <a:ext cx="301680" cy="10152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35e600"/>
          </a:solidFill>
          <a:ln w="9360">
            <a:solidFill>
              <a:srgbClr val="35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2847960" y="723960"/>
            <a:ext cx="299880" cy="1015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67e600"/>
          </a:solidFill>
          <a:ln w="9360">
            <a:solidFill>
              <a:srgbClr val="6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3147840" y="723960"/>
            <a:ext cx="303480" cy="1015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da"/>
          </a:solidFill>
          <a:ln w="9360">
            <a:solidFill>
              <a:srgbClr val="00e6da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3451320" y="723960"/>
            <a:ext cx="299880" cy="10152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6be6"/>
          </a:solidFill>
          <a:ln w="9360">
            <a:solidFill>
              <a:srgbClr val="006b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244600" y="620640"/>
            <a:ext cx="3016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31"/>
          </a:solidFill>
          <a:ln w="9360">
            <a:solidFill>
              <a:srgbClr val="00e63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2546280" y="620640"/>
            <a:ext cx="301680" cy="103320"/>
          </a:xfrm>
          <a:custGeom>
            <a:avLst/>
            <a:gdLst/>
            <a:ahLst/>
            <a:rect l="l" t="t" r="r" b="b"/>
            <a:pathLst>
              <a:path w="690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0"/>
                </a:lnTo>
                <a:lnTo>
                  <a:pt x="690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48e600"/>
          </a:solidFill>
          <a:ln w="9360">
            <a:solidFill>
              <a:srgbClr val="4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2847960" y="62064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cee600"/>
          </a:solidFill>
          <a:ln w="9360">
            <a:solidFill>
              <a:srgbClr val="c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3147840" y="620640"/>
            <a:ext cx="3034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e6b0"/>
          </a:solidFill>
          <a:ln w="9360">
            <a:solidFill>
              <a:srgbClr val="00e6b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3451320" y="620640"/>
            <a:ext cx="299880" cy="103320"/>
          </a:xfrm>
          <a:custGeom>
            <a:avLst/>
            <a:gdLst/>
            <a:ahLst/>
            <a:rect l="l" t="t" r="r" b="b"/>
            <a:pathLst>
              <a:path w="691" h="230">
                <a:moveTo>
                  <a:pt x="0" y="23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0"/>
                </a:lnTo>
                <a:lnTo>
                  <a:pt x="691" y="230"/>
                </a:lnTo>
                <a:lnTo>
                  <a:pt x="0" y="230"/>
                </a:lnTo>
                <a:close/>
              </a:path>
            </a:pathLst>
          </a:custGeom>
          <a:solidFill>
            <a:srgbClr val="00d6e6"/>
          </a:solidFill>
          <a:ln w="9360">
            <a:solidFill>
              <a:srgbClr val="00d6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2244600" y="517680"/>
            <a:ext cx="3016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e600"/>
          </a:solidFill>
          <a:ln w="9360">
            <a:solidFill>
              <a:srgbClr val="00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2546280" y="517680"/>
            <a:ext cx="301680" cy="102960"/>
          </a:xfrm>
          <a:custGeom>
            <a:avLst/>
            <a:gdLst/>
            <a:ahLst/>
            <a:rect l="l" t="t" r="r" b="b"/>
            <a:pathLst>
              <a:path w="690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231"/>
                </a:lnTo>
                <a:lnTo>
                  <a:pt x="690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2ee600"/>
          </a:solidFill>
          <a:ln w="9360">
            <a:solidFill>
              <a:srgbClr val="2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847960" y="517680"/>
            <a:ext cx="2998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e6cb00"/>
          </a:solidFill>
          <a:ln w="9360">
            <a:solidFill>
              <a:srgbClr val="e6cb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3147840" y="517680"/>
            <a:ext cx="3034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50e6"/>
          </a:solidFill>
          <a:ln w="9360">
            <a:solidFill>
              <a:srgbClr val="0050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3451320" y="517680"/>
            <a:ext cx="299880" cy="102960"/>
          </a:xfrm>
          <a:custGeom>
            <a:avLst/>
            <a:gdLst/>
            <a:ahLst/>
            <a:rect l="l" t="t" r="r" b="b"/>
            <a:pathLst>
              <a:path w="691" h="231">
                <a:moveTo>
                  <a:pt x="0" y="23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231"/>
                </a:lnTo>
                <a:lnTo>
                  <a:pt x="691" y="231"/>
                </a:lnTo>
                <a:lnTo>
                  <a:pt x="0" y="231"/>
                </a:lnTo>
                <a:close/>
              </a:path>
            </a:pathLst>
          </a:custGeom>
          <a:solidFill>
            <a:srgbClr val="00bfe6"/>
          </a:solidFill>
          <a:ln w="9360">
            <a:solidFill>
              <a:srgbClr val="00bf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2244600" y="517680"/>
            <a:ext cx="1506600" cy="307800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4670280" y="2274840"/>
            <a:ext cx="38160" cy="81000"/>
          </a:xfrm>
          <a:custGeom>
            <a:avLst/>
            <a:gdLst/>
            <a:ahLst/>
            <a:rect l="l" t="t" r="r" b="b"/>
            <a:pathLst>
              <a:path w="75" h="150">
                <a:moveTo>
                  <a:pt x="0" y="150"/>
                </a:moveTo>
                <a:lnTo>
                  <a:pt x="0" y="0"/>
                </a:lnTo>
                <a:lnTo>
                  <a:pt x="0" y="0"/>
                </a:lnTo>
                <a:lnTo>
                  <a:pt x="75" y="0"/>
                </a:lnTo>
                <a:lnTo>
                  <a:pt x="75" y="0"/>
                </a:lnTo>
                <a:lnTo>
                  <a:pt x="75" y="150"/>
                </a:lnTo>
                <a:lnTo>
                  <a:pt x="75" y="150"/>
                </a:lnTo>
                <a:lnTo>
                  <a:pt x="0" y="15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4662360" y="2227320"/>
            <a:ext cx="93960" cy="95040"/>
          </a:xfrm>
          <a:prstGeom prst="rect">
            <a:avLst/>
          </a:prstGeom>
          <a:solidFill>
            <a:srgbClr val="2200e6"/>
          </a:solidFill>
          <a:ln w="9360">
            <a:solidFill>
              <a:srgbClr val="2200e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4784400" y="219852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4662360" y="2106720"/>
            <a:ext cx="93960" cy="96840"/>
          </a:xfrm>
          <a:prstGeom prst="rect">
            <a:avLst/>
          </a:prstGeom>
          <a:solidFill>
            <a:srgbClr val="007ae6"/>
          </a:solidFill>
          <a:ln w="9360">
            <a:solidFill>
              <a:srgbClr val="007ae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4784400" y="207792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4662360" y="1986120"/>
            <a:ext cx="93960" cy="96840"/>
          </a:xfrm>
          <a:prstGeom prst="rect">
            <a:avLst/>
          </a:prstGeom>
          <a:solidFill>
            <a:srgbClr val="00e6b4"/>
          </a:solidFill>
          <a:ln w="9360">
            <a:solidFill>
              <a:srgbClr val="00e6b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4784400" y="195912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4662360" y="1866960"/>
            <a:ext cx="93960" cy="95040"/>
          </a:xfrm>
          <a:prstGeom prst="rect">
            <a:avLst/>
          </a:prstGeom>
          <a:solidFill>
            <a:srgbClr val="00e616"/>
          </a:solidFill>
          <a:ln w="9360">
            <a:solidFill>
              <a:srgbClr val="00e61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4784400" y="183816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4662360" y="1746360"/>
            <a:ext cx="93960" cy="95040"/>
          </a:xfrm>
          <a:prstGeom prst="rect">
            <a:avLst/>
          </a:prstGeom>
          <a:solidFill>
            <a:srgbClr val="8ae600"/>
          </a:solidFill>
          <a:ln w="9360">
            <a:solidFill>
              <a:srgbClr val="8a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4826520" y="171756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4662360" y="1625760"/>
            <a:ext cx="93960" cy="96840"/>
          </a:xfrm>
          <a:prstGeom prst="rect">
            <a:avLst/>
          </a:prstGeom>
          <a:solidFill>
            <a:srgbClr val="e6a400"/>
          </a:solidFill>
          <a:ln w="9360">
            <a:solidFill>
              <a:srgbClr val="e6a4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4826520" y="159696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4662360" y="1504800"/>
            <a:ext cx="93960" cy="96840"/>
          </a:xfrm>
          <a:prstGeom prst="rect">
            <a:avLst/>
          </a:prstGeom>
          <a:solidFill>
            <a:srgbClr val="e60700"/>
          </a:solidFill>
          <a:ln w="9360">
            <a:solidFill>
              <a:srgbClr val="e607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4826520" y="147168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3751200" y="517680"/>
            <a:ext cx="603360" cy="3078000"/>
          </a:xfrm>
          <a:custGeom>
            <a:avLst/>
            <a:gdLst/>
            <a:ahLst/>
            <a:rect l="l" t="t" r="r" b="b"/>
            <a:pathLst>
              <a:path w="1152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1152" y="0"/>
                </a:lnTo>
                <a:lnTo>
                  <a:pt x="1152" y="0"/>
                </a:lnTo>
                <a:lnTo>
                  <a:pt x="1152" y="5760"/>
                </a:lnTo>
                <a:lnTo>
                  <a:pt x="1152" y="5760"/>
                </a:lnTo>
                <a:lnTo>
                  <a:pt x="0" y="576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3751200" y="1082520"/>
            <a:ext cx="4752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3751200" y="979560"/>
            <a:ext cx="4752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3751200" y="1492200"/>
            <a:ext cx="11124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3751200" y="568440"/>
            <a:ext cx="9360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3751200" y="774720"/>
            <a:ext cx="11268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3751200" y="671400"/>
            <a:ext cx="9360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3751200" y="876240"/>
            <a:ext cx="11268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3751200" y="1184400"/>
            <a:ext cx="6840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3751200" y="2416320"/>
            <a:ext cx="6372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3751200" y="1800360"/>
            <a:ext cx="12240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751200" y="1595520"/>
            <a:ext cx="11268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3751200" y="1390680"/>
            <a:ext cx="11124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3751200" y="2825640"/>
            <a:ext cx="6840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3751200" y="2006640"/>
            <a:ext cx="9684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3751200" y="2928960"/>
            <a:ext cx="6840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3751200" y="2108160"/>
            <a:ext cx="8892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3751200" y="2209680"/>
            <a:ext cx="8892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3751200" y="3441600"/>
            <a:ext cx="4464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3751200" y="2722680"/>
            <a:ext cx="8748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3751200" y="2519280"/>
            <a:ext cx="6372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3751200" y="3135240"/>
            <a:ext cx="8748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3751200" y="2313000"/>
            <a:ext cx="7956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3751200" y="1287360"/>
            <a:ext cx="6840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3751200" y="3338640"/>
            <a:ext cx="3672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3751200" y="1697040"/>
            <a:ext cx="11268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751200" y="1903320"/>
            <a:ext cx="9684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3751200" y="3236760"/>
            <a:ext cx="3672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3751200" y="3544920"/>
            <a:ext cx="27612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3751200" y="2622600"/>
            <a:ext cx="8748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3751200" y="3032280"/>
            <a:ext cx="12564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3787920" y="3287880"/>
            <a:ext cx="7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3795840" y="3390840"/>
            <a:ext cx="42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3798720" y="10303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3814920" y="2467080"/>
            <a:ext cx="15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3819600" y="2878200"/>
            <a:ext cx="79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3819600" y="123660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3830760" y="2365200"/>
            <a:ext cx="29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3838680" y="3186000"/>
            <a:ext cx="38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3838680" y="2671920"/>
            <a:ext cx="117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3840120" y="2158920"/>
            <a:ext cx="20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3844800" y="620640"/>
            <a:ext cx="114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3848040" y="1954080"/>
            <a:ext cx="25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3860640" y="2262240"/>
            <a:ext cx="122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3862440" y="1441440"/>
            <a:ext cx="33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3863880" y="82548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3863880" y="1646280"/>
            <a:ext cx="69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3873600" y="1852560"/>
            <a:ext cx="60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3875040" y="927000"/>
            <a:ext cx="84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3876840" y="3083040"/>
            <a:ext cx="21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3895560" y="1339920"/>
            <a:ext cx="113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3898800" y="2979720"/>
            <a:ext cx="57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3933720" y="1749600"/>
            <a:ext cx="4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3956040" y="277488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3959280" y="723960"/>
            <a:ext cx="4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3983040" y="2057400"/>
            <a:ext cx="114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4008600" y="1133640"/>
            <a:ext cx="8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4027320" y="3494160"/>
            <a:ext cx="238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4097160" y="1542960"/>
            <a:ext cx="168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4265640" y="2570040"/>
            <a:ext cx="8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 flipV="1">
            <a:off x="3798720" y="979560"/>
            <a:ext cx="0" cy="102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3798720" y="979560"/>
            <a:ext cx="0" cy="102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 flipV="1">
            <a:off x="3862440" y="139068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3844800" y="568440"/>
            <a:ext cx="0" cy="102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3863880" y="77472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 flipV="1">
            <a:off x="3844800" y="568440"/>
            <a:ext cx="0" cy="102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 flipV="1">
            <a:off x="3863880" y="77472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3819600" y="1184400"/>
            <a:ext cx="0" cy="102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3814920" y="2416320"/>
            <a:ext cx="0" cy="102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3873600" y="1800360"/>
            <a:ext cx="0" cy="153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863880" y="159552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3862440" y="139068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3819600" y="2825640"/>
            <a:ext cx="0" cy="103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 flipV="1">
            <a:off x="3848040" y="1902960"/>
            <a:ext cx="0" cy="103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 flipV="1">
            <a:off x="3819600" y="2825280"/>
            <a:ext cx="0" cy="103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3840120" y="210816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 flipV="1">
            <a:off x="3840120" y="210816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 flipV="1">
            <a:off x="3795840" y="3287520"/>
            <a:ext cx="0" cy="153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 flipV="1">
            <a:off x="3838680" y="2622600"/>
            <a:ext cx="0" cy="100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 flipV="1">
            <a:off x="3814920" y="2416320"/>
            <a:ext cx="0" cy="102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3838680" y="3135240"/>
            <a:ext cx="0" cy="255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3830760" y="2313000"/>
            <a:ext cx="0" cy="154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 flipV="1">
            <a:off x="3819600" y="1184400"/>
            <a:ext cx="0" cy="102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 flipV="1">
            <a:off x="3787920" y="3236400"/>
            <a:ext cx="0" cy="101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 flipV="1">
            <a:off x="3863880" y="1595520"/>
            <a:ext cx="0" cy="10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3848040" y="1903320"/>
            <a:ext cx="0" cy="103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3787920" y="3236760"/>
            <a:ext cx="0" cy="101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 flipV="1">
            <a:off x="4027320" y="2774520"/>
            <a:ext cx="0" cy="770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3838680" y="2622600"/>
            <a:ext cx="0" cy="100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3876840" y="3032280"/>
            <a:ext cx="0" cy="153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3795840" y="3287880"/>
            <a:ext cx="0" cy="153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 flipV="1">
            <a:off x="3838680" y="3135240"/>
            <a:ext cx="0" cy="255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 flipV="1">
            <a:off x="3875040" y="825120"/>
            <a:ext cx="0" cy="204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 flipV="1">
            <a:off x="3830760" y="2313000"/>
            <a:ext cx="0" cy="154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3898800" y="2878200"/>
            <a:ext cx="0" cy="204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3895560" y="1236600"/>
            <a:ext cx="0" cy="204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 flipV="1">
            <a:off x="3860640" y="2158560"/>
            <a:ext cx="0" cy="206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 flipV="1">
            <a:off x="3876840" y="3031920"/>
            <a:ext cx="0" cy="153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3956040" y="2671920"/>
            <a:ext cx="0" cy="307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3860640" y="2158920"/>
            <a:ext cx="0" cy="206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3959280" y="620640"/>
            <a:ext cx="0" cy="306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 flipV="1">
            <a:off x="3873600" y="1800000"/>
            <a:ext cx="0" cy="153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 flipV="1">
            <a:off x="3983040" y="1749600"/>
            <a:ext cx="0" cy="512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 flipV="1">
            <a:off x="3895560" y="1236240"/>
            <a:ext cx="0" cy="204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3875040" y="825480"/>
            <a:ext cx="0" cy="204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3933720" y="1646280"/>
            <a:ext cx="0" cy="206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 flipV="1">
            <a:off x="3933720" y="1645920"/>
            <a:ext cx="0" cy="206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 flipV="1">
            <a:off x="3959280" y="620280"/>
            <a:ext cx="0" cy="306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 flipV="1">
            <a:off x="3898800" y="2877840"/>
            <a:ext cx="0" cy="204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 flipV="1">
            <a:off x="4008600" y="723600"/>
            <a:ext cx="0" cy="61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 flipV="1">
            <a:off x="3956040" y="2671560"/>
            <a:ext cx="0" cy="307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3983040" y="1749600"/>
            <a:ext cx="0" cy="512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4027320" y="2774880"/>
            <a:ext cx="0" cy="770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4008600" y="723960"/>
            <a:ext cx="0" cy="61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 flipV="1">
            <a:off x="4097160" y="1133640"/>
            <a:ext cx="0" cy="923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4097160" y="1133640"/>
            <a:ext cx="0" cy="923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 flipV="1">
            <a:off x="4265640" y="1542960"/>
            <a:ext cx="0" cy="1951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4265640" y="1542960"/>
            <a:ext cx="0" cy="1951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2244600" y="3595680"/>
            <a:ext cx="1506600" cy="615960"/>
          </a:xfrm>
          <a:custGeom>
            <a:avLst/>
            <a:gdLst/>
            <a:ahLst/>
            <a:rect l="l" t="t" r="r" b="b"/>
            <a:pathLst>
              <a:path w="2879" h="1152">
                <a:moveTo>
                  <a:pt x="0" y="1152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1152"/>
                </a:lnTo>
                <a:lnTo>
                  <a:pt x="2879" y="1152"/>
                </a:lnTo>
                <a:lnTo>
                  <a:pt x="0" y="1152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2395440" y="3595680"/>
            <a:ext cx="0" cy="281160"/>
          </a:xfrm>
          <a:prstGeom prst="line">
            <a:avLst/>
          </a:prstGeom>
          <a:ln w="9360">
            <a:solidFill>
              <a:srgbClr val="8d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2697120" y="3595680"/>
            <a:ext cx="0" cy="281160"/>
          </a:xfrm>
          <a:prstGeom prst="line">
            <a:avLst/>
          </a:prstGeom>
          <a:ln w="9360">
            <a:solidFill>
              <a:srgbClr val="8d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2998800" y="3595680"/>
            <a:ext cx="0" cy="387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3298680" y="3595680"/>
            <a:ext cx="0" cy="21744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3602160" y="3595680"/>
            <a:ext cx="0" cy="21744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3451320" y="3813120"/>
            <a:ext cx="0" cy="246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2546280" y="3876840"/>
            <a:ext cx="0" cy="106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2847960" y="398304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3147840" y="405936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2395440" y="3876840"/>
            <a:ext cx="30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 flipH="1">
            <a:off x="2395440" y="3876840"/>
            <a:ext cx="30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 flipH="1">
            <a:off x="2545920" y="3983040"/>
            <a:ext cx="452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3298680" y="3813120"/>
            <a:ext cx="303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 flipH="1">
            <a:off x="3298320" y="3813120"/>
            <a:ext cx="303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 flipH="1">
            <a:off x="2847960" y="4059360"/>
            <a:ext cx="603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2546280" y="3983040"/>
            <a:ext cx="452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2847960" y="4059360"/>
            <a:ext cx="603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2244600" y="517680"/>
            <a:ext cx="1506600" cy="307800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1642680" y="527040"/>
            <a:ext cx="240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ps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1643760" y="630360"/>
            <a:ext cx="238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zd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1640520" y="733320"/>
            <a:ext cx="249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pd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1628640" y="833400"/>
            <a:ext cx="360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lyc-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1639440" y="936720"/>
            <a:ext cx="267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cm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1641960" y="1039680"/>
            <a:ext cx="241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dx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1644480" y="1143000"/>
            <a:ext cx="279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lyc-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1628640" y="1244520"/>
            <a:ext cx="505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lyc-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1628640" y="1347840"/>
            <a:ext cx="432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chy-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1635840" y="1449360"/>
            <a:ext cx="246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hdr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1642320" y="1552680"/>
            <a:ext cx="331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nced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1644840" y="1654200"/>
            <a:ext cx="37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nced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1642320" y="1757520"/>
            <a:ext cx="331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nced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1644840" y="1860480"/>
            <a:ext cx="37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nced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1643760" y="1962000"/>
            <a:ext cx="24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ze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1644480" y="2065320"/>
            <a:ext cx="28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dx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1641960" y="2166840"/>
            <a:ext cx="31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cm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1628640" y="2268360"/>
            <a:ext cx="432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lyc-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1642320" y="2371680"/>
            <a:ext cx="284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ccd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1643040" y="2475000"/>
            <a:ext cx="294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pd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1646280" y="2577960"/>
            <a:ext cx="288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ze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1643760" y="2679840"/>
            <a:ext cx="284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PHB_ps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1628640" y="2782800"/>
            <a:ext cx="432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chy-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1642320" y="2884320"/>
            <a:ext cx="284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_ccd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1644840" y="2987640"/>
            <a:ext cx="329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ccd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1646280" y="3089160"/>
            <a:ext cx="284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zd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1628640" y="3192480"/>
            <a:ext cx="432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chy-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1644840" y="3295800"/>
            <a:ext cx="329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ccd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1638360" y="3397320"/>
            <a:ext cx="291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hdr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1628640" y="3498840"/>
            <a:ext cx="432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RHB_chy-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2244600" y="517680"/>
            <a:ext cx="1506600" cy="307800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2310480" y="3240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2612160" y="3240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2912400" y="3240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3217680" y="324000"/>
            <a:ext cx="162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B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3515400" y="3240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4076640" y="4832280"/>
            <a:ext cx="1239840" cy="256212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4076640" y="7224840"/>
            <a:ext cx="247680" cy="16956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e6b800"/>
          </a:solidFill>
          <a:ln w="9360">
            <a:solidFill>
              <a:srgbClr val="e6b8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4324320" y="7224840"/>
            <a:ext cx="247680" cy="169560"/>
          </a:xfrm>
          <a:custGeom>
            <a:avLst/>
            <a:gdLst/>
            <a:ahLst/>
            <a:rect l="l" t="t" r="r" b="b"/>
            <a:pathLst>
              <a:path w="690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0"/>
                </a:lnTo>
                <a:lnTo>
                  <a:pt x="690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e69100"/>
          </a:solidFill>
          <a:ln w="9360">
            <a:solidFill>
              <a:srgbClr val="e691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4572000" y="7224840"/>
            <a:ext cx="247680" cy="16956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e67300"/>
          </a:solidFill>
          <a:ln w="9360">
            <a:solidFill>
              <a:srgbClr val="e67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4819680" y="7224840"/>
            <a:ext cx="249120" cy="169560"/>
          </a:xfrm>
          <a:custGeom>
            <a:avLst/>
            <a:gdLst/>
            <a:ahLst/>
            <a:rect l="l" t="t" r="r" b="b"/>
            <a:pathLst>
              <a:path w="692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0"/>
                </a:lnTo>
                <a:lnTo>
                  <a:pt x="692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e66b00"/>
          </a:solidFill>
          <a:ln w="9360">
            <a:solidFill>
              <a:srgbClr val="e66b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5068800" y="7224840"/>
            <a:ext cx="247680" cy="16956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cbe600"/>
          </a:solidFill>
          <a:ln w="9360">
            <a:solidFill>
              <a:srgbClr val="cb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4076640" y="7053120"/>
            <a:ext cx="24768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41e600"/>
          </a:solidFill>
          <a:ln w="9360">
            <a:solidFill>
              <a:srgbClr val="4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4324320" y="7053120"/>
            <a:ext cx="247680" cy="17172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1ae600"/>
          </a:solidFill>
          <a:ln w="9360">
            <a:solidFill>
              <a:srgbClr val="1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4572000" y="7053120"/>
            <a:ext cx="24768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7300"/>
          </a:solidFill>
          <a:ln w="9360">
            <a:solidFill>
              <a:srgbClr val="e67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4819680" y="7053120"/>
            <a:ext cx="249120" cy="17172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da00"/>
          </a:solidFill>
          <a:ln w="9360">
            <a:solidFill>
              <a:srgbClr val="e6da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5068800" y="7053120"/>
            <a:ext cx="24768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39e600"/>
          </a:solidFill>
          <a:ln w="9360">
            <a:solidFill>
              <a:srgbClr val="39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4076640" y="688176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41"/>
          </a:solidFill>
          <a:ln w="9360">
            <a:solidFill>
              <a:srgbClr val="00e64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4324320" y="6881760"/>
            <a:ext cx="247680" cy="1713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41e600"/>
          </a:solidFill>
          <a:ln w="9360">
            <a:solidFill>
              <a:srgbClr val="4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4572000" y="688176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bbe600"/>
          </a:solidFill>
          <a:ln w="9360">
            <a:solidFill>
              <a:srgbClr val="bb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4819680" y="6881760"/>
            <a:ext cx="249120" cy="17136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6fe600"/>
          </a:solidFill>
          <a:ln w="9360">
            <a:solidFill>
              <a:srgbClr val="6f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5068800" y="688176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99e600"/>
          </a:solidFill>
          <a:ln w="9360">
            <a:solidFill>
              <a:srgbClr val="99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4076640" y="6711840"/>
            <a:ext cx="247680" cy="1699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1ae600"/>
          </a:solidFill>
          <a:ln w="9360">
            <a:solidFill>
              <a:srgbClr val="1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4324320" y="6711840"/>
            <a:ext cx="247680" cy="16992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7ee600"/>
          </a:solidFill>
          <a:ln w="9360">
            <a:solidFill>
              <a:srgbClr val="7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4572000" y="6711840"/>
            <a:ext cx="247680" cy="1699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4ce600"/>
          </a:solidFill>
          <a:ln w="9360">
            <a:solidFill>
              <a:srgbClr val="4c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4819680" y="6711840"/>
            <a:ext cx="249120" cy="16992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2ee600"/>
          </a:solidFill>
          <a:ln w="9360">
            <a:solidFill>
              <a:srgbClr val="2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5068800" y="6711840"/>
            <a:ext cx="247680" cy="1699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6fe600"/>
          </a:solidFill>
          <a:ln w="9360">
            <a:solidFill>
              <a:srgbClr val="6f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4076640" y="654048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5be600"/>
          </a:solidFill>
          <a:ln w="9360">
            <a:solidFill>
              <a:srgbClr val="5b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4324320" y="6540480"/>
            <a:ext cx="247680" cy="1713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5fe600"/>
          </a:solidFill>
          <a:ln w="9360">
            <a:solidFill>
              <a:srgbClr val="5f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4572000" y="654048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48e600"/>
          </a:solidFill>
          <a:ln w="9360">
            <a:solidFill>
              <a:srgbClr val="4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4819680" y="6540480"/>
            <a:ext cx="249120" cy="17136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48e600"/>
          </a:solidFill>
          <a:ln w="9360">
            <a:solidFill>
              <a:srgbClr val="4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5068800" y="654048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b7e600"/>
          </a:solidFill>
          <a:ln w="9360">
            <a:solidFill>
              <a:srgbClr val="b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4076640" y="636912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91e600"/>
          </a:solidFill>
          <a:ln w="9360">
            <a:solidFill>
              <a:srgbClr val="9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4324320" y="6369120"/>
            <a:ext cx="247680" cy="1713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6fe600"/>
          </a:solidFill>
          <a:ln w="9360">
            <a:solidFill>
              <a:srgbClr val="6f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4572000" y="636912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63e600"/>
          </a:solidFill>
          <a:ln w="9360">
            <a:solidFill>
              <a:srgbClr val="6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4819680" y="6369120"/>
            <a:ext cx="249120" cy="17136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41e600"/>
          </a:solidFill>
          <a:ln w="9360">
            <a:solidFill>
              <a:srgbClr val="4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5068800" y="636912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5fe600"/>
          </a:solidFill>
          <a:ln w="9360">
            <a:solidFill>
              <a:srgbClr val="5f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4076640" y="6199200"/>
            <a:ext cx="247680" cy="1699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1e"/>
          </a:solidFill>
          <a:ln w="9360">
            <a:solidFill>
              <a:srgbClr val="00e61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4324320" y="6199200"/>
            <a:ext cx="247680" cy="16992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5be600"/>
          </a:solidFill>
          <a:ln w="9360">
            <a:solidFill>
              <a:srgbClr val="5b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4572000" y="6199200"/>
            <a:ext cx="247680" cy="1699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cee600"/>
          </a:solidFill>
          <a:ln w="9360">
            <a:solidFill>
              <a:srgbClr val="c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4819680" y="6199200"/>
            <a:ext cx="249120" cy="16992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ace600"/>
          </a:solidFill>
          <a:ln w="9360">
            <a:solidFill>
              <a:srgbClr val="ac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5068800" y="6199200"/>
            <a:ext cx="247680" cy="1699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67e6"/>
          </a:solidFill>
          <a:ln w="9360">
            <a:solidFill>
              <a:srgbClr val="0067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4076640" y="6027840"/>
            <a:ext cx="247680" cy="17136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00e686"/>
          </a:solidFill>
          <a:ln w="9360">
            <a:solidFill>
              <a:srgbClr val="00e68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4324320" y="6027840"/>
            <a:ext cx="247680" cy="171360"/>
          </a:xfrm>
          <a:custGeom>
            <a:avLst/>
            <a:gdLst/>
            <a:ahLst/>
            <a:rect l="l" t="t" r="r" b="b"/>
            <a:pathLst>
              <a:path w="690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0"/>
                </a:lnTo>
                <a:lnTo>
                  <a:pt x="690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e2e600"/>
          </a:solidFill>
          <a:ln w="9360">
            <a:solidFill>
              <a:srgbClr val="e2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4572000" y="6027840"/>
            <a:ext cx="247680" cy="17136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54e600"/>
          </a:solidFill>
          <a:ln w="9360">
            <a:solidFill>
              <a:srgbClr val="54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4819680" y="6027840"/>
            <a:ext cx="249120" cy="171360"/>
          </a:xfrm>
          <a:custGeom>
            <a:avLst/>
            <a:gdLst/>
            <a:ahLst/>
            <a:rect l="l" t="t" r="r" b="b"/>
            <a:pathLst>
              <a:path w="692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0"/>
                </a:lnTo>
                <a:lnTo>
                  <a:pt x="692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2ee600"/>
          </a:solidFill>
          <a:ln w="9360">
            <a:solidFill>
              <a:srgbClr val="2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5068800" y="6027840"/>
            <a:ext cx="247680" cy="17136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0089e6"/>
          </a:solidFill>
          <a:ln w="9360">
            <a:solidFill>
              <a:srgbClr val="0089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4076640" y="5857920"/>
            <a:ext cx="247680" cy="1699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07e6"/>
          </a:solidFill>
          <a:ln w="9360">
            <a:solidFill>
              <a:srgbClr val="0007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4324320" y="5857920"/>
            <a:ext cx="247680" cy="16992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da"/>
          </a:solidFill>
          <a:ln w="9360">
            <a:solidFill>
              <a:srgbClr val="00e6da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4572000" y="5857920"/>
            <a:ext cx="247680" cy="1699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8de600"/>
          </a:solidFill>
          <a:ln w="9360">
            <a:solidFill>
              <a:srgbClr val="8d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4819680" y="5857920"/>
            <a:ext cx="249120" cy="16992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1e"/>
          </a:solidFill>
          <a:ln w="9360">
            <a:solidFill>
              <a:srgbClr val="00e61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5068800" y="5857920"/>
            <a:ext cx="247680" cy="1699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5c"/>
          </a:solidFill>
          <a:ln w="9360">
            <a:solidFill>
              <a:srgbClr val="00e65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4076640" y="568656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95e6"/>
          </a:solidFill>
          <a:ln w="9360">
            <a:solidFill>
              <a:srgbClr val="0095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4324320" y="5686560"/>
            <a:ext cx="247680" cy="1713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a1e6"/>
          </a:solidFill>
          <a:ln w="9360">
            <a:solidFill>
              <a:srgbClr val="00a1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4572000" y="568656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17e600"/>
          </a:solidFill>
          <a:ln w="9360">
            <a:solidFill>
              <a:srgbClr val="1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4819680" y="5686560"/>
            <a:ext cx="249120" cy="17136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cb"/>
          </a:solidFill>
          <a:ln w="9360">
            <a:solidFill>
              <a:srgbClr val="00e6c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5068800" y="568656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91e600"/>
          </a:solidFill>
          <a:ln w="9360">
            <a:solidFill>
              <a:srgbClr val="9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4076640" y="5514840"/>
            <a:ext cx="24768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cf"/>
          </a:solidFill>
          <a:ln w="9360">
            <a:solidFill>
              <a:srgbClr val="00e6c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4324320" y="5514840"/>
            <a:ext cx="247680" cy="17172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0b"/>
          </a:solidFill>
          <a:ln w="9360">
            <a:solidFill>
              <a:srgbClr val="00e60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4572000" y="5514840"/>
            <a:ext cx="24768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bb"/>
          </a:solidFill>
          <a:ln w="9360">
            <a:solidFill>
              <a:srgbClr val="00e6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4819680" y="5514840"/>
            <a:ext cx="249120" cy="17172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73"/>
          </a:solidFill>
          <a:ln w="9360">
            <a:solidFill>
              <a:srgbClr val="00e67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5068800" y="5514840"/>
            <a:ext cx="24768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26"/>
          </a:solidFill>
          <a:ln w="9360">
            <a:solidFill>
              <a:srgbClr val="00e62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4076640" y="5345280"/>
            <a:ext cx="247680" cy="1695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bb"/>
          </a:solidFill>
          <a:ln w="9360">
            <a:solidFill>
              <a:srgbClr val="00e6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4324320" y="5345280"/>
            <a:ext cx="247680" cy="1695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6f"/>
          </a:solidFill>
          <a:ln w="9360">
            <a:solidFill>
              <a:srgbClr val="00e66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4572000" y="5345280"/>
            <a:ext cx="247680" cy="1695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44"/>
          </a:solidFill>
          <a:ln w="9360">
            <a:solidFill>
              <a:srgbClr val="00e64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4819680" y="5345280"/>
            <a:ext cx="249120" cy="16956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1e"/>
          </a:solidFill>
          <a:ln w="9360">
            <a:solidFill>
              <a:srgbClr val="00e61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5068800" y="5345280"/>
            <a:ext cx="247680" cy="1695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d2"/>
          </a:solidFill>
          <a:ln w="9360">
            <a:solidFill>
              <a:srgbClr val="00e6d2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4076640" y="5173560"/>
            <a:ext cx="24768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76"/>
          </a:solidFill>
          <a:ln w="9360">
            <a:solidFill>
              <a:srgbClr val="00e67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4324320" y="5173560"/>
            <a:ext cx="247680" cy="17172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67e600"/>
          </a:solidFill>
          <a:ln w="9360">
            <a:solidFill>
              <a:srgbClr val="6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4572000" y="5173560"/>
            <a:ext cx="24768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2ee600"/>
          </a:solidFill>
          <a:ln w="9360">
            <a:solidFill>
              <a:srgbClr val="2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4819680" y="5173560"/>
            <a:ext cx="249120" cy="17172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26"/>
          </a:solidFill>
          <a:ln w="9360">
            <a:solidFill>
              <a:srgbClr val="00e62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5068800" y="5173560"/>
            <a:ext cx="24768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5f"/>
          </a:solidFill>
          <a:ln w="9360">
            <a:solidFill>
              <a:srgbClr val="00e65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4076640" y="5003640"/>
            <a:ext cx="247680" cy="16992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0fe600"/>
          </a:solidFill>
          <a:ln w="9360">
            <a:solidFill>
              <a:srgbClr val="0f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4324320" y="5003640"/>
            <a:ext cx="247680" cy="169920"/>
          </a:xfrm>
          <a:custGeom>
            <a:avLst/>
            <a:gdLst/>
            <a:ahLst/>
            <a:rect l="l" t="t" r="r" b="b"/>
            <a:pathLst>
              <a:path w="690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0"/>
                </a:lnTo>
                <a:lnTo>
                  <a:pt x="690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00e61e"/>
          </a:solidFill>
          <a:ln w="9360">
            <a:solidFill>
              <a:srgbClr val="00e61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4572000" y="5003640"/>
            <a:ext cx="247680" cy="16992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00e607"/>
          </a:solidFill>
          <a:ln w="9360">
            <a:solidFill>
              <a:srgbClr val="00e607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4819680" y="5003640"/>
            <a:ext cx="249120" cy="169920"/>
          </a:xfrm>
          <a:custGeom>
            <a:avLst/>
            <a:gdLst/>
            <a:ahLst/>
            <a:rect l="l" t="t" r="r" b="b"/>
            <a:pathLst>
              <a:path w="692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0"/>
                </a:lnTo>
                <a:lnTo>
                  <a:pt x="692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00e60b"/>
          </a:solidFill>
          <a:ln w="9360">
            <a:solidFill>
              <a:srgbClr val="00e60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5068800" y="5003640"/>
            <a:ext cx="247680" cy="16992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00e600"/>
          </a:solidFill>
          <a:ln w="9360">
            <a:solidFill>
              <a:srgbClr val="00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4076640" y="483228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63"/>
          </a:solidFill>
          <a:ln w="9360">
            <a:solidFill>
              <a:srgbClr val="00e66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4324320" y="4832280"/>
            <a:ext cx="247680" cy="1713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a4e6"/>
          </a:solidFill>
          <a:ln w="9360">
            <a:solidFill>
              <a:srgbClr val="00a4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4572000" y="483228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9de6"/>
          </a:solidFill>
          <a:ln w="9360">
            <a:solidFill>
              <a:srgbClr val="009d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4819680" y="4832280"/>
            <a:ext cx="249120" cy="171360"/>
          </a:xfrm>
          <a:custGeom>
            <a:avLst/>
            <a:gdLst/>
            <a:ahLst/>
            <a:rect l="l" t="t" r="r" b="b"/>
            <a:pathLst>
              <a:path w="692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2" y="0"/>
                </a:lnTo>
                <a:lnTo>
                  <a:pt x="692" y="0"/>
                </a:lnTo>
                <a:lnTo>
                  <a:pt x="692" y="461"/>
                </a:lnTo>
                <a:lnTo>
                  <a:pt x="692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dae6"/>
          </a:solidFill>
          <a:ln w="9360">
            <a:solidFill>
              <a:srgbClr val="00da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5068800" y="4832280"/>
            <a:ext cx="2476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5f"/>
          </a:solidFill>
          <a:ln w="9360">
            <a:solidFill>
              <a:srgbClr val="00e65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4076640" y="4832280"/>
            <a:ext cx="1239840" cy="256212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5958000" y="6375240"/>
            <a:ext cx="33120" cy="66960"/>
          </a:xfrm>
          <a:custGeom>
            <a:avLst/>
            <a:gdLst/>
            <a:ahLst/>
            <a:rect l="l" t="t" r="r" b="b"/>
            <a:pathLst>
              <a:path w="75" h="150">
                <a:moveTo>
                  <a:pt x="0" y="150"/>
                </a:moveTo>
                <a:lnTo>
                  <a:pt x="0" y="0"/>
                </a:lnTo>
                <a:lnTo>
                  <a:pt x="0" y="0"/>
                </a:lnTo>
                <a:lnTo>
                  <a:pt x="75" y="0"/>
                </a:lnTo>
                <a:lnTo>
                  <a:pt x="75" y="0"/>
                </a:lnTo>
                <a:lnTo>
                  <a:pt x="75" y="150"/>
                </a:lnTo>
                <a:lnTo>
                  <a:pt x="75" y="150"/>
                </a:lnTo>
                <a:lnTo>
                  <a:pt x="0" y="15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5951520" y="6335640"/>
            <a:ext cx="77760" cy="79560"/>
          </a:xfrm>
          <a:prstGeom prst="rect">
            <a:avLst/>
          </a:prstGeom>
          <a:solidFill>
            <a:srgbClr val="2200e6"/>
          </a:solidFill>
          <a:ln w="9360">
            <a:solidFill>
              <a:srgbClr val="2200e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6052680" y="629280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5951520" y="6235560"/>
            <a:ext cx="77760" cy="79560"/>
          </a:xfrm>
          <a:prstGeom prst="rect">
            <a:avLst/>
          </a:prstGeom>
          <a:solidFill>
            <a:srgbClr val="0099e6"/>
          </a:solidFill>
          <a:ln w="9360">
            <a:solidFill>
              <a:srgbClr val="0099e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6052680" y="619272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5951520" y="6135840"/>
            <a:ext cx="77760" cy="79200"/>
          </a:xfrm>
          <a:prstGeom prst="rect">
            <a:avLst/>
          </a:prstGeom>
          <a:solidFill>
            <a:srgbClr val="00e673"/>
          </a:solidFill>
          <a:ln w="9360">
            <a:solidFill>
              <a:srgbClr val="00e67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6052680" y="609300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5951520" y="6035760"/>
            <a:ext cx="77760" cy="79200"/>
          </a:xfrm>
          <a:prstGeom prst="rect">
            <a:avLst/>
          </a:prstGeom>
          <a:solidFill>
            <a:srgbClr val="48e600"/>
          </a:solidFill>
          <a:ln w="9360">
            <a:solidFill>
              <a:srgbClr val="48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6094800" y="599292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5951520" y="5935680"/>
            <a:ext cx="77760" cy="79200"/>
          </a:xfrm>
          <a:prstGeom prst="rect">
            <a:avLst/>
          </a:prstGeom>
          <a:solidFill>
            <a:srgbClr val="e6c300"/>
          </a:solidFill>
          <a:ln w="9360">
            <a:solidFill>
              <a:srgbClr val="e6c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6094800" y="588960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5951520" y="5835600"/>
            <a:ext cx="77760" cy="79560"/>
          </a:xfrm>
          <a:prstGeom prst="rect">
            <a:avLst/>
          </a:prstGeom>
          <a:solidFill>
            <a:srgbClr val="e60700"/>
          </a:solidFill>
          <a:ln w="9360">
            <a:solidFill>
              <a:srgbClr val="e607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6094800" y="579276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5324400" y="5592600"/>
            <a:ext cx="9540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5324400" y="5423040"/>
            <a:ext cx="9540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5324400" y="6446880"/>
            <a:ext cx="4788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5324400" y="6276960"/>
            <a:ext cx="9360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5324400" y="5081760"/>
            <a:ext cx="8568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5324400" y="6959520"/>
            <a:ext cx="9360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5324400" y="5251320"/>
            <a:ext cx="8568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5324400" y="4910040"/>
            <a:ext cx="23508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5324400" y="6618240"/>
            <a:ext cx="3960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5324400" y="5935680"/>
            <a:ext cx="13644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5324400" y="5764320"/>
            <a:ext cx="13644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5324400" y="6789600"/>
            <a:ext cx="3960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5324400" y="7302600"/>
            <a:ext cx="20160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5324400" y="6105600"/>
            <a:ext cx="9360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5324400" y="7130880"/>
            <a:ext cx="13644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5364000" y="6703920"/>
            <a:ext cx="8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5372280" y="6532560"/>
            <a:ext cx="45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5410080" y="5165640"/>
            <a:ext cx="33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5418000" y="6873840"/>
            <a:ext cx="42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5418000" y="6191280"/>
            <a:ext cx="209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5419800" y="550872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5443560" y="5337000"/>
            <a:ext cx="8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5460840" y="7045200"/>
            <a:ext cx="65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5460840" y="5850000"/>
            <a:ext cx="69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5526000" y="7216920"/>
            <a:ext cx="101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5530680" y="5678640"/>
            <a:ext cx="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5559480" y="4995720"/>
            <a:ext cx="217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5627520" y="6362640"/>
            <a:ext cx="149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5776920" y="6019920"/>
            <a:ext cx="4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 flipV="1">
            <a:off x="5419800" y="5422680"/>
            <a:ext cx="0" cy="16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5419800" y="5423040"/>
            <a:ext cx="0" cy="16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5372280" y="6446880"/>
            <a:ext cx="0" cy="257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 flipV="1">
            <a:off x="5418000" y="6105600"/>
            <a:ext cx="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>
            <a:off x="5410080" y="5081760"/>
            <a:ext cx="0" cy="16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 flipV="1">
            <a:off x="5418000" y="6532560"/>
            <a:ext cx="0" cy="426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 flipV="1">
            <a:off x="5410080" y="5081400"/>
            <a:ext cx="0" cy="16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>
            <a:off x="5559480" y="4910040"/>
            <a:ext cx="0" cy="76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>
            <a:off x="5364000" y="6618240"/>
            <a:ext cx="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 flipV="1">
            <a:off x="5460840" y="5764320"/>
            <a:ext cx="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>
            <a:off x="5460840" y="5764320"/>
            <a:ext cx="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 flipV="1">
            <a:off x="5364000" y="6618240"/>
            <a:ext cx="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 flipV="1">
            <a:off x="5526000" y="7044840"/>
            <a:ext cx="0" cy="257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5418000" y="6105600"/>
            <a:ext cx="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 flipV="1">
            <a:off x="5460840" y="6873840"/>
            <a:ext cx="0" cy="257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 flipV="1">
            <a:off x="5372280" y="6446880"/>
            <a:ext cx="0" cy="257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>
            <a:off x="5418000" y="6532560"/>
            <a:ext cx="0" cy="426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>
            <a:off x="5443560" y="5165640"/>
            <a:ext cx="0" cy="343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5460840" y="6873840"/>
            <a:ext cx="0" cy="257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>
            <a:off x="5627520" y="6191280"/>
            <a:ext cx="0" cy="1025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 flipV="1">
            <a:off x="5443560" y="5165280"/>
            <a:ext cx="0" cy="343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>
            <a:off x="5530680" y="5337000"/>
            <a:ext cx="0" cy="513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>
            <a:off x="5526000" y="7045200"/>
            <a:ext cx="0" cy="257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 flipV="1">
            <a:off x="5530680" y="5336640"/>
            <a:ext cx="0" cy="513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 flipV="1">
            <a:off x="5627520" y="6190920"/>
            <a:ext cx="0" cy="1025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 flipV="1">
            <a:off x="5559480" y="4909680"/>
            <a:ext cx="0" cy="76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>
            <a:off x="5776920" y="4995720"/>
            <a:ext cx="0" cy="1366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"/>
          <p:cNvSpPr/>
          <p:nvPr/>
        </p:nvSpPr>
        <p:spPr>
          <a:xfrm flipV="1">
            <a:off x="5776920" y="4995360"/>
            <a:ext cx="0" cy="1366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"/>
          <p:cNvSpPr/>
          <p:nvPr/>
        </p:nvSpPr>
        <p:spPr>
          <a:xfrm>
            <a:off x="4084560" y="7396200"/>
            <a:ext cx="1239840" cy="512640"/>
          </a:xfrm>
          <a:custGeom>
            <a:avLst/>
            <a:gdLst/>
            <a:ahLst/>
            <a:rect l="l" t="t" r="r" b="b"/>
            <a:pathLst>
              <a:path w="2879" h="1152">
                <a:moveTo>
                  <a:pt x="0" y="1152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1152"/>
                </a:lnTo>
                <a:lnTo>
                  <a:pt x="2879" y="1152"/>
                </a:lnTo>
                <a:lnTo>
                  <a:pt x="0" y="1152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>
            <a:off x="5200560" y="7396200"/>
            <a:ext cx="0" cy="406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>
            <a:off x="4208400" y="7396200"/>
            <a:ext cx="0" cy="27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>
            <a:off x="4456080" y="7396200"/>
            <a:ext cx="0" cy="27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>
            <a:off x="4951440" y="7396200"/>
            <a:ext cx="0" cy="15876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>
            <a:off x="4703760" y="7396200"/>
            <a:ext cx="0" cy="15876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4827600" y="7554960"/>
            <a:ext cx="0" cy="247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>
            <a:off x="4332240" y="767556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5076720" y="7802640"/>
            <a:ext cx="0" cy="15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>
            <a:off x="4579920" y="7818480"/>
            <a:ext cx="0" cy="90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 flipH="1">
            <a:off x="4827600" y="7802640"/>
            <a:ext cx="372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4208400" y="7675560"/>
            <a:ext cx="247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 flipH="1">
            <a:off x="4208400" y="7675560"/>
            <a:ext cx="247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"/>
          <p:cNvSpPr/>
          <p:nvPr/>
        </p:nvSpPr>
        <p:spPr>
          <a:xfrm flipH="1">
            <a:off x="4703760" y="7554960"/>
            <a:ext cx="247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"/>
          <p:cNvSpPr/>
          <p:nvPr/>
        </p:nvSpPr>
        <p:spPr>
          <a:xfrm>
            <a:off x="4703760" y="7554960"/>
            <a:ext cx="247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"/>
          <p:cNvSpPr/>
          <p:nvPr/>
        </p:nvSpPr>
        <p:spPr>
          <a:xfrm>
            <a:off x="4827600" y="7802640"/>
            <a:ext cx="372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"/>
          <p:cNvSpPr/>
          <p:nvPr/>
        </p:nvSpPr>
        <p:spPr>
          <a:xfrm>
            <a:off x="4332240" y="7818480"/>
            <a:ext cx="744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"/>
          <p:cNvSpPr/>
          <p:nvPr/>
        </p:nvSpPr>
        <p:spPr>
          <a:xfrm flipH="1">
            <a:off x="4332240" y="7818480"/>
            <a:ext cx="744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"/>
          <p:cNvSpPr/>
          <p:nvPr/>
        </p:nvSpPr>
        <p:spPr>
          <a:xfrm>
            <a:off x="4084560" y="4824360"/>
            <a:ext cx="1239840" cy="256212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"/>
          <p:cNvSpPr/>
          <p:nvPr/>
        </p:nvSpPr>
        <p:spPr>
          <a:xfrm>
            <a:off x="3645000" y="4863960"/>
            <a:ext cx="28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lyc-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"/>
          <p:cNvSpPr/>
          <p:nvPr/>
        </p:nvSpPr>
        <p:spPr>
          <a:xfrm>
            <a:off x="3645360" y="5035680"/>
            <a:ext cx="163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p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"/>
          <p:cNvSpPr/>
          <p:nvPr/>
        </p:nvSpPr>
        <p:spPr>
          <a:xfrm>
            <a:off x="3646440" y="5205240"/>
            <a:ext cx="210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lyc-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3644640" y="5375160"/>
            <a:ext cx="186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cm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>
            <a:off x="3647880" y="5546880"/>
            <a:ext cx="153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dx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"/>
          <p:cNvSpPr/>
          <p:nvPr/>
        </p:nvSpPr>
        <p:spPr>
          <a:xfrm>
            <a:off x="3648600" y="5715000"/>
            <a:ext cx="27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nced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3648600" y="5884920"/>
            <a:ext cx="27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nce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>
            <a:off x="3649320" y="605628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ze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3648600" y="6226200"/>
            <a:ext cx="15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ps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3638520" y="6397560"/>
            <a:ext cx="160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hd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>
            <a:off x="3648600" y="6566040"/>
            <a:ext cx="208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cc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3651840" y="6735600"/>
            <a:ext cx="23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chy-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"/>
          <p:cNvSpPr/>
          <p:nvPr/>
        </p:nvSpPr>
        <p:spPr>
          <a:xfrm>
            <a:off x="3649320" y="6905520"/>
            <a:ext cx="150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z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>
            <a:off x="3648600" y="7077240"/>
            <a:ext cx="208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cc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3645000" y="7251840"/>
            <a:ext cx="360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chy-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4084560" y="4824360"/>
            <a:ext cx="1239840" cy="256212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4115520" y="46641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"/>
          <p:cNvSpPr/>
          <p:nvPr/>
        </p:nvSpPr>
        <p:spPr>
          <a:xfrm>
            <a:off x="4363200" y="46641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"/>
          <p:cNvSpPr/>
          <p:nvPr/>
        </p:nvSpPr>
        <p:spPr>
          <a:xfrm>
            <a:off x="4610880" y="46641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"/>
          <p:cNvSpPr/>
          <p:nvPr/>
        </p:nvSpPr>
        <p:spPr>
          <a:xfrm>
            <a:off x="4862520" y="4664160"/>
            <a:ext cx="162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B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>
            <a:off x="5107680" y="46641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>
            <a:off x="1085760" y="4818240"/>
            <a:ext cx="1293840" cy="258264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"/>
          <p:cNvSpPr/>
          <p:nvPr/>
        </p:nvSpPr>
        <p:spPr>
          <a:xfrm>
            <a:off x="1085760" y="722952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b7e600"/>
          </a:solidFill>
          <a:ln w="9360">
            <a:solidFill>
              <a:srgbClr val="b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"/>
          <p:cNvSpPr/>
          <p:nvPr/>
        </p:nvSpPr>
        <p:spPr>
          <a:xfrm>
            <a:off x="1344600" y="7229520"/>
            <a:ext cx="258840" cy="1713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da00"/>
          </a:solidFill>
          <a:ln w="9360">
            <a:solidFill>
              <a:srgbClr val="e6da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"/>
          <p:cNvSpPr/>
          <p:nvPr/>
        </p:nvSpPr>
        <p:spPr>
          <a:xfrm>
            <a:off x="1603440" y="722952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82e600"/>
          </a:solidFill>
          <a:ln w="9360">
            <a:solidFill>
              <a:srgbClr val="82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"/>
          <p:cNvSpPr/>
          <p:nvPr/>
        </p:nvSpPr>
        <p:spPr>
          <a:xfrm>
            <a:off x="1862280" y="7229520"/>
            <a:ext cx="2584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4800"/>
          </a:solidFill>
          <a:ln w="9360">
            <a:solidFill>
              <a:srgbClr val="e648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"/>
          <p:cNvSpPr/>
          <p:nvPr/>
        </p:nvSpPr>
        <p:spPr>
          <a:xfrm>
            <a:off x="2120760" y="722952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8d00"/>
          </a:solidFill>
          <a:ln w="9360">
            <a:solidFill>
              <a:srgbClr val="e68d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"/>
          <p:cNvSpPr/>
          <p:nvPr/>
        </p:nvSpPr>
        <p:spPr>
          <a:xfrm>
            <a:off x="1085760" y="705636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cee600"/>
          </a:solidFill>
          <a:ln w="9360">
            <a:solidFill>
              <a:srgbClr val="c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"/>
          <p:cNvSpPr/>
          <p:nvPr/>
        </p:nvSpPr>
        <p:spPr>
          <a:xfrm>
            <a:off x="1344600" y="7056360"/>
            <a:ext cx="258840" cy="1731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8de600"/>
          </a:solidFill>
          <a:ln w="9360">
            <a:solidFill>
              <a:srgbClr val="8d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"/>
          <p:cNvSpPr/>
          <p:nvPr/>
        </p:nvSpPr>
        <p:spPr>
          <a:xfrm>
            <a:off x="1603440" y="705636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3e600"/>
          </a:solidFill>
          <a:ln w="9360">
            <a:solidFill>
              <a:srgbClr val="0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"/>
          <p:cNvSpPr/>
          <p:nvPr/>
        </p:nvSpPr>
        <p:spPr>
          <a:xfrm>
            <a:off x="1862280" y="7056360"/>
            <a:ext cx="25848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a800"/>
          </a:solidFill>
          <a:ln w="9360">
            <a:solidFill>
              <a:srgbClr val="e6a8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>
            <a:off x="2120760" y="705636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6700"/>
          </a:solidFill>
          <a:ln w="9360">
            <a:solidFill>
              <a:srgbClr val="e667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>
            <a:off x="1085760" y="688500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7ee600"/>
          </a:solidFill>
          <a:ln w="9360">
            <a:solidFill>
              <a:srgbClr val="7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>
            <a:off x="1344600" y="6885000"/>
            <a:ext cx="258840" cy="1713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35e600"/>
          </a:solidFill>
          <a:ln w="9360">
            <a:solidFill>
              <a:srgbClr val="35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"/>
          <p:cNvSpPr/>
          <p:nvPr/>
        </p:nvSpPr>
        <p:spPr>
          <a:xfrm>
            <a:off x="1603440" y="688500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a8e600"/>
          </a:solidFill>
          <a:ln w="9360">
            <a:solidFill>
              <a:srgbClr val="a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"/>
          <p:cNvSpPr/>
          <p:nvPr/>
        </p:nvSpPr>
        <p:spPr>
          <a:xfrm>
            <a:off x="1862280" y="6885000"/>
            <a:ext cx="2584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cb00"/>
          </a:solidFill>
          <a:ln w="9360">
            <a:solidFill>
              <a:srgbClr val="e6cb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"/>
          <p:cNvSpPr/>
          <p:nvPr/>
        </p:nvSpPr>
        <p:spPr>
          <a:xfrm>
            <a:off x="2120760" y="688500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dae600"/>
          </a:solidFill>
          <a:ln w="9360">
            <a:solidFill>
              <a:srgbClr val="d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"/>
          <p:cNvSpPr/>
          <p:nvPr/>
        </p:nvSpPr>
        <p:spPr>
          <a:xfrm>
            <a:off x="1085760" y="6713640"/>
            <a:ext cx="258840" cy="17136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1ae600"/>
          </a:solidFill>
          <a:ln w="9360">
            <a:solidFill>
              <a:srgbClr val="1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"/>
          <p:cNvSpPr/>
          <p:nvPr/>
        </p:nvSpPr>
        <p:spPr>
          <a:xfrm>
            <a:off x="1344600" y="6713640"/>
            <a:ext cx="258840" cy="171360"/>
          </a:xfrm>
          <a:custGeom>
            <a:avLst/>
            <a:gdLst/>
            <a:ahLst/>
            <a:rect l="l" t="t" r="r" b="b"/>
            <a:pathLst>
              <a:path w="690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0"/>
                </a:lnTo>
                <a:lnTo>
                  <a:pt x="690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2ee600"/>
          </a:solidFill>
          <a:ln w="9360">
            <a:solidFill>
              <a:srgbClr val="2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"/>
          <p:cNvSpPr/>
          <p:nvPr/>
        </p:nvSpPr>
        <p:spPr>
          <a:xfrm>
            <a:off x="1603440" y="6713640"/>
            <a:ext cx="258840" cy="17136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c7e600"/>
          </a:solidFill>
          <a:ln w="9360">
            <a:solidFill>
              <a:srgbClr val="c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"/>
          <p:cNvSpPr/>
          <p:nvPr/>
        </p:nvSpPr>
        <p:spPr>
          <a:xfrm>
            <a:off x="1862280" y="6713640"/>
            <a:ext cx="258480" cy="17136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2ae600"/>
          </a:solidFill>
          <a:ln w="9360">
            <a:solidFill>
              <a:srgbClr val="2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>
            <a:off x="2120760" y="6713640"/>
            <a:ext cx="258840" cy="17136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e67e00"/>
          </a:solidFill>
          <a:ln w="9360">
            <a:solidFill>
              <a:srgbClr val="e67e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1085760" y="654048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a8e6"/>
          </a:solidFill>
          <a:ln w="9360">
            <a:solidFill>
              <a:srgbClr val="00a8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>
            <a:off x="1344600" y="6540480"/>
            <a:ext cx="258840" cy="1731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cf"/>
          </a:solidFill>
          <a:ln w="9360">
            <a:solidFill>
              <a:srgbClr val="00e6c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1603440" y="654048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82e600"/>
          </a:solidFill>
          <a:ln w="9360">
            <a:solidFill>
              <a:srgbClr val="82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1862280" y="6540480"/>
            <a:ext cx="25848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48e600"/>
          </a:solidFill>
          <a:ln w="9360">
            <a:solidFill>
              <a:srgbClr val="4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>
            <a:off x="2120760" y="654048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b4e600"/>
          </a:solidFill>
          <a:ln w="9360">
            <a:solidFill>
              <a:srgbClr val="b4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>
            <a:off x="1085760" y="636912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7a"/>
          </a:solidFill>
          <a:ln w="9360">
            <a:solidFill>
              <a:srgbClr val="00e67a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1344600" y="6369120"/>
            <a:ext cx="258840" cy="1713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48e600"/>
          </a:solidFill>
          <a:ln w="9360">
            <a:solidFill>
              <a:srgbClr val="4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>
            <a:off x="1603440" y="636912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b400"/>
          </a:solidFill>
          <a:ln w="9360">
            <a:solidFill>
              <a:srgbClr val="e6b4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>
            <a:off x="1862280" y="6369120"/>
            <a:ext cx="2584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7e600"/>
          </a:solidFill>
          <a:ln w="9360">
            <a:solidFill>
              <a:srgbClr val="0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>
            <a:off x="2120760" y="636912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1ee600"/>
          </a:solidFill>
          <a:ln w="9360">
            <a:solidFill>
              <a:srgbClr val="1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>
            <a:off x="1085760" y="619596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6f"/>
          </a:solidFill>
          <a:ln w="9360">
            <a:solidFill>
              <a:srgbClr val="00e66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>
            <a:off x="1344600" y="6195960"/>
            <a:ext cx="258840" cy="1731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9900"/>
          </a:solidFill>
          <a:ln w="9360">
            <a:solidFill>
              <a:srgbClr val="e699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1603440" y="619596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7ae600"/>
          </a:solidFill>
          <a:ln w="9360">
            <a:solidFill>
              <a:srgbClr val="7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>
            <a:off x="1862280" y="6195960"/>
            <a:ext cx="25848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07"/>
          </a:solidFill>
          <a:ln w="9360">
            <a:solidFill>
              <a:srgbClr val="00e607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>
            <a:off x="2120760" y="619596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07"/>
          </a:solidFill>
          <a:ln w="9360">
            <a:solidFill>
              <a:srgbClr val="00e607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>
            <a:off x="1085760" y="602280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b4e6"/>
          </a:solidFill>
          <a:ln w="9360">
            <a:solidFill>
              <a:srgbClr val="00b4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>
            <a:off x="1344600" y="6022800"/>
            <a:ext cx="258840" cy="1731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9100"/>
          </a:solidFill>
          <a:ln w="9360">
            <a:solidFill>
              <a:srgbClr val="e691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"/>
          <p:cNvSpPr/>
          <p:nvPr/>
        </p:nvSpPr>
        <p:spPr>
          <a:xfrm>
            <a:off x="1603440" y="602280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a8e600"/>
          </a:solidFill>
          <a:ln w="9360">
            <a:solidFill>
              <a:srgbClr val="a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"/>
          <p:cNvSpPr/>
          <p:nvPr/>
        </p:nvSpPr>
        <p:spPr>
          <a:xfrm>
            <a:off x="1862280" y="6022800"/>
            <a:ext cx="25848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cfe6"/>
          </a:solidFill>
          <a:ln w="9360">
            <a:solidFill>
              <a:srgbClr val="00cf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"/>
          <p:cNvSpPr/>
          <p:nvPr/>
        </p:nvSpPr>
        <p:spPr>
          <a:xfrm>
            <a:off x="2120760" y="6022800"/>
            <a:ext cx="258840" cy="1731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5f"/>
          </a:solidFill>
          <a:ln w="9360">
            <a:solidFill>
              <a:srgbClr val="00e65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"/>
          <p:cNvSpPr/>
          <p:nvPr/>
        </p:nvSpPr>
        <p:spPr>
          <a:xfrm>
            <a:off x="1085760" y="585144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3e600"/>
          </a:solidFill>
          <a:ln w="9360">
            <a:solidFill>
              <a:srgbClr val="0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"/>
          <p:cNvSpPr/>
          <p:nvPr/>
        </p:nvSpPr>
        <p:spPr>
          <a:xfrm>
            <a:off x="1344600" y="5851440"/>
            <a:ext cx="258840" cy="1713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13e600"/>
          </a:solidFill>
          <a:ln w="9360">
            <a:solidFill>
              <a:srgbClr val="13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"/>
          <p:cNvSpPr/>
          <p:nvPr/>
        </p:nvSpPr>
        <p:spPr>
          <a:xfrm>
            <a:off x="1603440" y="585144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6be600"/>
          </a:solidFill>
          <a:ln w="9360">
            <a:solidFill>
              <a:srgbClr val="6b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"/>
          <p:cNvSpPr/>
          <p:nvPr/>
        </p:nvSpPr>
        <p:spPr>
          <a:xfrm>
            <a:off x="1862280" y="5851440"/>
            <a:ext cx="2584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16"/>
          </a:solidFill>
          <a:ln w="9360">
            <a:solidFill>
              <a:srgbClr val="00e61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"/>
          <p:cNvSpPr/>
          <p:nvPr/>
        </p:nvSpPr>
        <p:spPr>
          <a:xfrm>
            <a:off x="2120760" y="585144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07e6"/>
          </a:solidFill>
          <a:ln w="9360">
            <a:solidFill>
              <a:srgbClr val="0007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"/>
          <p:cNvSpPr/>
          <p:nvPr/>
        </p:nvSpPr>
        <p:spPr>
          <a:xfrm>
            <a:off x="1085760" y="5678640"/>
            <a:ext cx="258840" cy="17280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00e616"/>
          </a:solidFill>
          <a:ln w="9360">
            <a:solidFill>
              <a:srgbClr val="00e61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"/>
          <p:cNvSpPr/>
          <p:nvPr/>
        </p:nvSpPr>
        <p:spPr>
          <a:xfrm>
            <a:off x="1344600" y="5678640"/>
            <a:ext cx="258840" cy="172800"/>
          </a:xfrm>
          <a:custGeom>
            <a:avLst/>
            <a:gdLst/>
            <a:ahLst/>
            <a:rect l="l" t="t" r="r" b="b"/>
            <a:pathLst>
              <a:path w="690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0"/>
                </a:lnTo>
                <a:lnTo>
                  <a:pt x="690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26e600"/>
          </a:solidFill>
          <a:ln w="9360">
            <a:solidFill>
              <a:srgbClr val="26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>
            <a:off x="1603440" y="5678640"/>
            <a:ext cx="258840" cy="17280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7ae600"/>
          </a:solidFill>
          <a:ln w="9360">
            <a:solidFill>
              <a:srgbClr val="7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>
            <a:off x="1862280" y="5678640"/>
            <a:ext cx="258480" cy="17280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00e66f"/>
          </a:solidFill>
          <a:ln w="9360">
            <a:solidFill>
              <a:srgbClr val="00e66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>
            <a:off x="2120760" y="5678640"/>
            <a:ext cx="258840" cy="172800"/>
          </a:xfrm>
          <a:custGeom>
            <a:avLst/>
            <a:gdLst/>
            <a:ahLst/>
            <a:rect l="l" t="t" r="r" b="b"/>
            <a:pathLst>
              <a:path w="691" h="460">
                <a:moveTo>
                  <a:pt x="0" y="460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0"/>
                </a:lnTo>
                <a:lnTo>
                  <a:pt x="691" y="460"/>
                </a:lnTo>
                <a:lnTo>
                  <a:pt x="0" y="460"/>
                </a:lnTo>
                <a:close/>
              </a:path>
            </a:pathLst>
          </a:custGeom>
          <a:solidFill>
            <a:srgbClr val="0067e6"/>
          </a:solidFill>
          <a:ln w="9360">
            <a:solidFill>
              <a:srgbClr val="0067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>
            <a:off x="1085760" y="5506920"/>
            <a:ext cx="25884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0b"/>
          </a:solidFill>
          <a:ln w="9360">
            <a:solidFill>
              <a:srgbClr val="00e60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>
            <a:off x="1344600" y="5506920"/>
            <a:ext cx="258840" cy="17172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1ae600"/>
          </a:solidFill>
          <a:ln w="9360">
            <a:solidFill>
              <a:srgbClr val="1a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>
            <a:off x="1603440" y="5506920"/>
            <a:ext cx="25884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67e600"/>
          </a:solidFill>
          <a:ln w="9360">
            <a:solidFill>
              <a:srgbClr val="6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>
            <a:off x="1862280" y="5506920"/>
            <a:ext cx="25848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c3"/>
          </a:solidFill>
          <a:ln w="9360">
            <a:solidFill>
              <a:srgbClr val="00e6c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>
            <a:off x="2120760" y="5506920"/>
            <a:ext cx="25884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b7"/>
          </a:solidFill>
          <a:ln w="9360">
            <a:solidFill>
              <a:srgbClr val="00e6b7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>
            <a:off x="1085760" y="5334120"/>
            <a:ext cx="258840" cy="17280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58e600"/>
          </a:solidFill>
          <a:ln w="9360">
            <a:solidFill>
              <a:srgbClr val="58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>
            <a:off x="1344600" y="5334120"/>
            <a:ext cx="258840" cy="17280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fe600"/>
          </a:solidFill>
          <a:ln w="9360">
            <a:solidFill>
              <a:srgbClr val="0f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>
            <a:off x="1603440" y="5334120"/>
            <a:ext cx="258840" cy="17280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50e600"/>
          </a:solidFill>
          <a:ln w="9360">
            <a:solidFill>
              <a:srgbClr val="50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>
            <a:off x="1862280" y="5334120"/>
            <a:ext cx="258480" cy="17280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7ae6"/>
          </a:solidFill>
          <a:ln w="9360">
            <a:solidFill>
              <a:srgbClr val="007a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"/>
          <p:cNvSpPr/>
          <p:nvPr/>
        </p:nvSpPr>
        <p:spPr>
          <a:xfrm>
            <a:off x="2120760" y="5334120"/>
            <a:ext cx="258840" cy="17280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41e6"/>
          </a:solidFill>
          <a:ln w="9360">
            <a:solidFill>
              <a:srgbClr val="0041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"/>
          <p:cNvSpPr/>
          <p:nvPr/>
        </p:nvSpPr>
        <p:spPr>
          <a:xfrm>
            <a:off x="1085760" y="5162400"/>
            <a:ext cx="25884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dee600"/>
          </a:solidFill>
          <a:ln w="9360">
            <a:solidFill>
              <a:srgbClr val="de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"/>
          <p:cNvSpPr/>
          <p:nvPr/>
        </p:nvSpPr>
        <p:spPr>
          <a:xfrm>
            <a:off x="1344600" y="5162400"/>
            <a:ext cx="258840" cy="17172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a1e600"/>
          </a:solidFill>
          <a:ln w="9360">
            <a:solidFill>
              <a:srgbClr val="a1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"/>
          <p:cNvSpPr/>
          <p:nvPr/>
        </p:nvSpPr>
        <p:spPr>
          <a:xfrm>
            <a:off x="1603440" y="5162400"/>
            <a:ext cx="25884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de00"/>
          </a:solidFill>
          <a:ln w="9360">
            <a:solidFill>
              <a:srgbClr val="e6de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"/>
          <p:cNvSpPr/>
          <p:nvPr/>
        </p:nvSpPr>
        <p:spPr>
          <a:xfrm>
            <a:off x="1862280" y="5162400"/>
            <a:ext cx="25848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a1"/>
          </a:solidFill>
          <a:ln w="9360">
            <a:solidFill>
              <a:srgbClr val="00e6a1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"/>
          <p:cNvSpPr/>
          <p:nvPr/>
        </p:nvSpPr>
        <p:spPr>
          <a:xfrm>
            <a:off x="2120760" y="5162400"/>
            <a:ext cx="258840" cy="17172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86e6"/>
          </a:solidFill>
          <a:ln w="9360">
            <a:solidFill>
              <a:srgbClr val="0086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"/>
          <p:cNvSpPr/>
          <p:nvPr/>
        </p:nvSpPr>
        <p:spPr>
          <a:xfrm>
            <a:off x="1085760" y="499104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7300"/>
          </a:solidFill>
          <a:ln w="9360">
            <a:solidFill>
              <a:srgbClr val="e67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"/>
          <p:cNvSpPr/>
          <p:nvPr/>
        </p:nvSpPr>
        <p:spPr>
          <a:xfrm>
            <a:off x="1344600" y="4991040"/>
            <a:ext cx="258840" cy="17136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b7e600"/>
          </a:solidFill>
          <a:ln w="9360">
            <a:solidFill>
              <a:srgbClr val="b7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"/>
          <p:cNvSpPr/>
          <p:nvPr/>
        </p:nvSpPr>
        <p:spPr>
          <a:xfrm>
            <a:off x="1603440" y="499104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26e600"/>
          </a:solidFill>
          <a:ln w="9360">
            <a:solidFill>
              <a:srgbClr val="26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"/>
          <p:cNvSpPr/>
          <p:nvPr/>
        </p:nvSpPr>
        <p:spPr>
          <a:xfrm>
            <a:off x="1862280" y="4991040"/>
            <a:ext cx="25848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6f"/>
          </a:solidFill>
          <a:ln w="9360">
            <a:solidFill>
              <a:srgbClr val="00e66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"/>
          <p:cNvSpPr/>
          <p:nvPr/>
        </p:nvSpPr>
        <p:spPr>
          <a:xfrm>
            <a:off x="2120760" y="4991040"/>
            <a:ext cx="258840" cy="17136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c3"/>
          </a:solidFill>
          <a:ln w="9360">
            <a:solidFill>
              <a:srgbClr val="00e6c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"/>
          <p:cNvSpPr/>
          <p:nvPr/>
        </p:nvSpPr>
        <p:spPr>
          <a:xfrm>
            <a:off x="1085760" y="4818240"/>
            <a:ext cx="258840" cy="17280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e63100"/>
          </a:solidFill>
          <a:ln w="9360">
            <a:solidFill>
              <a:srgbClr val="e631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"/>
          <p:cNvSpPr/>
          <p:nvPr/>
        </p:nvSpPr>
        <p:spPr>
          <a:xfrm>
            <a:off x="1344600" y="4818240"/>
            <a:ext cx="258840" cy="172800"/>
          </a:xfrm>
          <a:custGeom>
            <a:avLst/>
            <a:gdLst/>
            <a:ahLst/>
            <a:rect l="l" t="t" r="r" b="b"/>
            <a:pathLst>
              <a:path w="690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0" y="0"/>
                </a:lnTo>
                <a:lnTo>
                  <a:pt x="690" y="0"/>
                </a:lnTo>
                <a:lnTo>
                  <a:pt x="690" y="461"/>
                </a:lnTo>
                <a:lnTo>
                  <a:pt x="690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9de600"/>
          </a:solidFill>
          <a:ln w="9360">
            <a:solidFill>
              <a:srgbClr val="9d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"/>
          <p:cNvSpPr/>
          <p:nvPr/>
        </p:nvSpPr>
        <p:spPr>
          <a:xfrm>
            <a:off x="1593720" y="4818240"/>
            <a:ext cx="258840" cy="17280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5fe600"/>
          </a:solidFill>
          <a:ln w="9360">
            <a:solidFill>
              <a:srgbClr val="5fe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"/>
          <p:cNvSpPr/>
          <p:nvPr/>
        </p:nvSpPr>
        <p:spPr>
          <a:xfrm>
            <a:off x="1862280" y="4818240"/>
            <a:ext cx="258480" cy="17280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67e6"/>
          </a:solidFill>
          <a:ln w="9360">
            <a:solidFill>
              <a:srgbClr val="0067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"/>
          <p:cNvSpPr/>
          <p:nvPr/>
        </p:nvSpPr>
        <p:spPr>
          <a:xfrm>
            <a:off x="2120760" y="4818240"/>
            <a:ext cx="258840" cy="172800"/>
          </a:xfrm>
          <a:custGeom>
            <a:avLst/>
            <a:gdLst/>
            <a:ahLst/>
            <a:rect l="l" t="t" r="r" b="b"/>
            <a:pathLst>
              <a:path w="691" h="461">
                <a:moveTo>
                  <a:pt x="0" y="461"/>
                </a:moveTo>
                <a:lnTo>
                  <a:pt x="0" y="0"/>
                </a:lnTo>
                <a:lnTo>
                  <a:pt x="0" y="0"/>
                </a:lnTo>
                <a:lnTo>
                  <a:pt x="691" y="0"/>
                </a:lnTo>
                <a:lnTo>
                  <a:pt x="691" y="0"/>
                </a:lnTo>
                <a:lnTo>
                  <a:pt x="691" y="461"/>
                </a:lnTo>
                <a:lnTo>
                  <a:pt x="691" y="461"/>
                </a:lnTo>
                <a:lnTo>
                  <a:pt x="0" y="461"/>
                </a:lnTo>
                <a:close/>
              </a:path>
            </a:pathLst>
          </a:custGeom>
          <a:solidFill>
            <a:srgbClr val="00e6de"/>
          </a:solidFill>
          <a:ln w="9360">
            <a:solidFill>
              <a:srgbClr val="00e6de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"/>
          <p:cNvSpPr/>
          <p:nvPr/>
        </p:nvSpPr>
        <p:spPr>
          <a:xfrm>
            <a:off x="1085760" y="4818240"/>
            <a:ext cx="1293840" cy="258264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"/>
          <p:cNvSpPr/>
          <p:nvPr/>
        </p:nvSpPr>
        <p:spPr>
          <a:xfrm>
            <a:off x="3003480" y="6389640"/>
            <a:ext cx="33480" cy="68400"/>
          </a:xfrm>
          <a:custGeom>
            <a:avLst/>
            <a:gdLst/>
            <a:ahLst/>
            <a:rect l="l" t="t" r="r" b="b"/>
            <a:pathLst>
              <a:path w="75" h="150">
                <a:moveTo>
                  <a:pt x="0" y="150"/>
                </a:moveTo>
                <a:lnTo>
                  <a:pt x="0" y="0"/>
                </a:lnTo>
                <a:lnTo>
                  <a:pt x="0" y="0"/>
                </a:lnTo>
                <a:lnTo>
                  <a:pt x="75" y="0"/>
                </a:lnTo>
                <a:lnTo>
                  <a:pt x="75" y="0"/>
                </a:lnTo>
                <a:lnTo>
                  <a:pt x="75" y="150"/>
                </a:lnTo>
                <a:lnTo>
                  <a:pt x="75" y="150"/>
                </a:lnTo>
                <a:lnTo>
                  <a:pt x="0" y="15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"/>
          <p:cNvSpPr/>
          <p:nvPr/>
        </p:nvSpPr>
        <p:spPr>
          <a:xfrm>
            <a:off x="2997360" y="6350040"/>
            <a:ext cx="80640" cy="81000"/>
          </a:xfrm>
          <a:prstGeom prst="rect">
            <a:avLst/>
          </a:prstGeom>
          <a:solidFill>
            <a:srgbClr val="2200e6"/>
          </a:solidFill>
          <a:ln w="9360">
            <a:solidFill>
              <a:srgbClr val="2200e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"/>
          <p:cNvSpPr/>
          <p:nvPr/>
        </p:nvSpPr>
        <p:spPr>
          <a:xfrm>
            <a:off x="3103200" y="630720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"/>
          <p:cNvSpPr/>
          <p:nvPr/>
        </p:nvSpPr>
        <p:spPr>
          <a:xfrm>
            <a:off x="2997360" y="6248520"/>
            <a:ext cx="80640" cy="81000"/>
          </a:xfrm>
          <a:prstGeom prst="rect">
            <a:avLst/>
          </a:prstGeom>
          <a:solidFill>
            <a:srgbClr val="0099e6"/>
          </a:solidFill>
          <a:ln w="9360">
            <a:solidFill>
              <a:srgbClr val="0099e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"/>
          <p:cNvSpPr/>
          <p:nvPr/>
        </p:nvSpPr>
        <p:spPr>
          <a:xfrm>
            <a:off x="3103200" y="620568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"/>
          <p:cNvSpPr/>
          <p:nvPr/>
        </p:nvSpPr>
        <p:spPr>
          <a:xfrm>
            <a:off x="2997360" y="6148440"/>
            <a:ext cx="80640" cy="79200"/>
          </a:xfrm>
          <a:prstGeom prst="rect">
            <a:avLst/>
          </a:prstGeom>
          <a:solidFill>
            <a:srgbClr val="00e673"/>
          </a:solidFill>
          <a:ln w="9360">
            <a:solidFill>
              <a:srgbClr val="00e67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"/>
          <p:cNvSpPr/>
          <p:nvPr/>
        </p:nvSpPr>
        <p:spPr>
          <a:xfrm>
            <a:off x="3103200" y="610560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"/>
          <p:cNvSpPr/>
          <p:nvPr/>
        </p:nvSpPr>
        <p:spPr>
          <a:xfrm>
            <a:off x="2997360" y="6046920"/>
            <a:ext cx="80640" cy="81000"/>
          </a:xfrm>
          <a:prstGeom prst="rect">
            <a:avLst/>
          </a:prstGeom>
          <a:solidFill>
            <a:srgbClr val="48e600"/>
          </a:solidFill>
          <a:ln w="9360">
            <a:solidFill>
              <a:srgbClr val="48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"/>
          <p:cNvSpPr/>
          <p:nvPr/>
        </p:nvSpPr>
        <p:spPr>
          <a:xfrm>
            <a:off x="3103200" y="600408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"/>
          <p:cNvSpPr/>
          <p:nvPr/>
        </p:nvSpPr>
        <p:spPr>
          <a:xfrm>
            <a:off x="2997360" y="5945040"/>
            <a:ext cx="80640" cy="81000"/>
          </a:xfrm>
          <a:prstGeom prst="rect">
            <a:avLst/>
          </a:prstGeom>
          <a:solidFill>
            <a:srgbClr val="e6c300"/>
          </a:solidFill>
          <a:ln w="9360">
            <a:solidFill>
              <a:srgbClr val="e6c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"/>
          <p:cNvSpPr/>
          <p:nvPr/>
        </p:nvSpPr>
        <p:spPr>
          <a:xfrm>
            <a:off x="3145320" y="590076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"/>
          <p:cNvSpPr/>
          <p:nvPr/>
        </p:nvSpPr>
        <p:spPr>
          <a:xfrm>
            <a:off x="2997360" y="5845320"/>
            <a:ext cx="80640" cy="80640"/>
          </a:xfrm>
          <a:prstGeom prst="rect">
            <a:avLst/>
          </a:prstGeom>
          <a:solidFill>
            <a:srgbClr val="e60700"/>
          </a:solidFill>
          <a:ln w="9360">
            <a:solidFill>
              <a:srgbClr val="e607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3840" bIns="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"/>
          <p:cNvSpPr/>
          <p:nvPr/>
        </p:nvSpPr>
        <p:spPr>
          <a:xfrm>
            <a:off x="3145320" y="5802480"/>
            <a:ext cx="7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"/>
          <p:cNvSpPr/>
          <p:nvPr/>
        </p:nvSpPr>
        <p:spPr>
          <a:xfrm>
            <a:off x="2379600" y="5937120"/>
            <a:ext cx="5580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"/>
          <p:cNvSpPr/>
          <p:nvPr/>
        </p:nvSpPr>
        <p:spPr>
          <a:xfrm>
            <a:off x="2379600" y="5765760"/>
            <a:ext cx="5580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"/>
          <p:cNvSpPr/>
          <p:nvPr/>
        </p:nvSpPr>
        <p:spPr>
          <a:xfrm>
            <a:off x="2379600" y="6110280"/>
            <a:ext cx="17136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"/>
          <p:cNvSpPr/>
          <p:nvPr/>
        </p:nvSpPr>
        <p:spPr>
          <a:xfrm>
            <a:off x="2379600" y="4903920"/>
            <a:ext cx="10656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"/>
          <p:cNvSpPr/>
          <p:nvPr/>
        </p:nvSpPr>
        <p:spPr>
          <a:xfrm>
            <a:off x="2379600" y="5248440"/>
            <a:ext cx="13032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"/>
          <p:cNvSpPr/>
          <p:nvPr/>
        </p:nvSpPr>
        <p:spPr>
          <a:xfrm>
            <a:off x="2379600" y="5076720"/>
            <a:ext cx="10656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"/>
          <p:cNvSpPr/>
          <p:nvPr/>
        </p:nvSpPr>
        <p:spPr>
          <a:xfrm>
            <a:off x="2379600" y="5421240"/>
            <a:ext cx="11268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"/>
          <p:cNvSpPr/>
          <p:nvPr/>
        </p:nvSpPr>
        <p:spPr>
          <a:xfrm>
            <a:off x="2379600" y="5592600"/>
            <a:ext cx="112680" cy="0"/>
          </a:xfrm>
          <a:prstGeom prst="line">
            <a:avLst/>
          </a:prstGeom>
          <a:ln w="9360">
            <a:solidFill>
              <a:srgbClr val="00e61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"/>
          <p:cNvSpPr/>
          <p:nvPr/>
        </p:nvSpPr>
        <p:spPr>
          <a:xfrm>
            <a:off x="2379600" y="6970680"/>
            <a:ext cx="10476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"/>
          <p:cNvSpPr/>
          <p:nvPr/>
        </p:nvSpPr>
        <p:spPr>
          <a:xfrm>
            <a:off x="2379600" y="6799320"/>
            <a:ext cx="17640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"/>
          <p:cNvSpPr/>
          <p:nvPr/>
        </p:nvSpPr>
        <p:spPr>
          <a:xfrm>
            <a:off x="2379600" y="6626160"/>
            <a:ext cx="273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"/>
          <p:cNvSpPr/>
          <p:nvPr/>
        </p:nvSpPr>
        <p:spPr>
          <a:xfrm>
            <a:off x="2379600" y="6281640"/>
            <a:ext cx="11592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"/>
          <p:cNvSpPr/>
          <p:nvPr/>
        </p:nvSpPr>
        <p:spPr>
          <a:xfrm>
            <a:off x="2379600" y="7143840"/>
            <a:ext cx="7776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"/>
          <p:cNvSpPr/>
          <p:nvPr/>
        </p:nvSpPr>
        <p:spPr>
          <a:xfrm>
            <a:off x="2379600" y="6453360"/>
            <a:ext cx="115920" cy="0"/>
          </a:xfrm>
          <a:prstGeom prst="line">
            <a:avLst/>
          </a:prstGeom>
          <a:ln w="9360">
            <a:solidFill>
              <a:srgbClr val="de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"/>
          <p:cNvSpPr/>
          <p:nvPr/>
        </p:nvSpPr>
        <p:spPr>
          <a:xfrm>
            <a:off x="2379600" y="7316640"/>
            <a:ext cx="77760" cy="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"/>
          <p:cNvSpPr/>
          <p:nvPr/>
        </p:nvSpPr>
        <p:spPr>
          <a:xfrm>
            <a:off x="2435400" y="5851440"/>
            <a:ext cx="79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"/>
          <p:cNvSpPr/>
          <p:nvPr/>
        </p:nvSpPr>
        <p:spPr>
          <a:xfrm>
            <a:off x="2457360" y="7229520"/>
            <a:ext cx="2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"/>
          <p:cNvSpPr/>
          <p:nvPr/>
        </p:nvSpPr>
        <p:spPr>
          <a:xfrm>
            <a:off x="2484360" y="7056360"/>
            <a:ext cx="7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"/>
          <p:cNvSpPr/>
          <p:nvPr/>
        </p:nvSpPr>
        <p:spPr>
          <a:xfrm>
            <a:off x="2486160" y="499104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"/>
          <p:cNvSpPr/>
          <p:nvPr/>
        </p:nvSpPr>
        <p:spPr>
          <a:xfrm>
            <a:off x="2492280" y="5506920"/>
            <a:ext cx="22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"/>
          <p:cNvSpPr/>
          <p:nvPr/>
        </p:nvSpPr>
        <p:spPr>
          <a:xfrm>
            <a:off x="2495520" y="6369120"/>
            <a:ext cx="55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"/>
          <p:cNvSpPr/>
          <p:nvPr/>
        </p:nvSpPr>
        <p:spPr>
          <a:xfrm>
            <a:off x="2509920" y="5162400"/>
            <a:ext cx="1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"/>
          <p:cNvSpPr/>
          <p:nvPr/>
        </p:nvSpPr>
        <p:spPr>
          <a:xfrm>
            <a:off x="2514600" y="5678640"/>
            <a:ext cx="103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"/>
          <p:cNvSpPr/>
          <p:nvPr/>
        </p:nvSpPr>
        <p:spPr>
          <a:xfrm>
            <a:off x="2550960" y="6195960"/>
            <a:ext cx="101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"/>
          <p:cNvSpPr/>
          <p:nvPr/>
        </p:nvSpPr>
        <p:spPr>
          <a:xfrm>
            <a:off x="2556000" y="6885000"/>
            <a:ext cx="185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"/>
          <p:cNvSpPr/>
          <p:nvPr/>
        </p:nvSpPr>
        <p:spPr>
          <a:xfrm>
            <a:off x="2617920" y="5334120"/>
            <a:ext cx="185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"/>
          <p:cNvSpPr/>
          <p:nvPr/>
        </p:nvSpPr>
        <p:spPr>
          <a:xfrm>
            <a:off x="2652840" y="6540480"/>
            <a:ext cx="8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"/>
          <p:cNvSpPr/>
          <p:nvPr/>
        </p:nvSpPr>
        <p:spPr>
          <a:xfrm>
            <a:off x="2741760" y="6713640"/>
            <a:ext cx="61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"/>
          <p:cNvSpPr/>
          <p:nvPr/>
        </p:nvSpPr>
        <p:spPr>
          <a:xfrm>
            <a:off x="2803680" y="6022800"/>
            <a:ext cx="95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"/>
          <p:cNvSpPr/>
          <p:nvPr/>
        </p:nvSpPr>
        <p:spPr>
          <a:xfrm flipV="1">
            <a:off x="2435400" y="5765760"/>
            <a:ext cx="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"/>
          <p:cNvSpPr/>
          <p:nvPr/>
        </p:nvSpPr>
        <p:spPr>
          <a:xfrm>
            <a:off x="2435400" y="5765760"/>
            <a:ext cx="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"/>
          <p:cNvSpPr/>
          <p:nvPr/>
        </p:nvSpPr>
        <p:spPr>
          <a:xfrm>
            <a:off x="2550960" y="6110280"/>
            <a:ext cx="0" cy="258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"/>
          <p:cNvSpPr/>
          <p:nvPr/>
        </p:nvSpPr>
        <p:spPr>
          <a:xfrm>
            <a:off x="2486160" y="4903920"/>
            <a:ext cx="0" cy="172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"/>
          <p:cNvSpPr/>
          <p:nvPr/>
        </p:nvSpPr>
        <p:spPr>
          <a:xfrm flipV="1">
            <a:off x="2509920" y="4990680"/>
            <a:ext cx="0" cy="257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"/>
          <p:cNvSpPr/>
          <p:nvPr/>
        </p:nvSpPr>
        <p:spPr>
          <a:xfrm flipV="1">
            <a:off x="2486160" y="4903920"/>
            <a:ext cx="0" cy="172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"/>
          <p:cNvSpPr/>
          <p:nvPr/>
        </p:nvSpPr>
        <p:spPr>
          <a:xfrm>
            <a:off x="2492280" y="5421240"/>
            <a:ext cx="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"/>
          <p:cNvSpPr/>
          <p:nvPr/>
        </p:nvSpPr>
        <p:spPr>
          <a:xfrm flipV="1">
            <a:off x="2492280" y="5421240"/>
            <a:ext cx="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"/>
          <p:cNvSpPr/>
          <p:nvPr/>
        </p:nvSpPr>
        <p:spPr>
          <a:xfrm>
            <a:off x="2484360" y="6970680"/>
            <a:ext cx="0" cy="258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"/>
          <p:cNvSpPr/>
          <p:nvPr/>
        </p:nvSpPr>
        <p:spPr>
          <a:xfrm>
            <a:off x="2556000" y="6799320"/>
            <a:ext cx="0" cy="257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"/>
          <p:cNvSpPr/>
          <p:nvPr/>
        </p:nvSpPr>
        <p:spPr>
          <a:xfrm flipV="1">
            <a:off x="2652840" y="6195600"/>
            <a:ext cx="0" cy="43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"/>
          <p:cNvSpPr/>
          <p:nvPr/>
        </p:nvSpPr>
        <p:spPr>
          <a:xfrm>
            <a:off x="2495520" y="6281640"/>
            <a:ext cx="0" cy="171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"/>
          <p:cNvSpPr/>
          <p:nvPr/>
        </p:nvSpPr>
        <p:spPr>
          <a:xfrm>
            <a:off x="2457360" y="7143840"/>
            <a:ext cx="0" cy="172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"/>
          <p:cNvSpPr/>
          <p:nvPr/>
        </p:nvSpPr>
        <p:spPr>
          <a:xfrm flipV="1">
            <a:off x="2495520" y="6281280"/>
            <a:ext cx="0" cy="171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"/>
          <p:cNvSpPr/>
          <p:nvPr/>
        </p:nvSpPr>
        <p:spPr>
          <a:xfrm flipV="1">
            <a:off x="2457360" y="7143840"/>
            <a:ext cx="0" cy="172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"/>
          <p:cNvSpPr/>
          <p:nvPr/>
        </p:nvSpPr>
        <p:spPr>
          <a:xfrm flipV="1">
            <a:off x="2514600" y="5506560"/>
            <a:ext cx="0" cy="344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"/>
          <p:cNvSpPr/>
          <p:nvPr/>
        </p:nvSpPr>
        <p:spPr>
          <a:xfrm flipV="1">
            <a:off x="2484360" y="6970320"/>
            <a:ext cx="0" cy="258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"/>
          <p:cNvSpPr/>
          <p:nvPr/>
        </p:nvSpPr>
        <p:spPr>
          <a:xfrm flipV="1">
            <a:off x="2556000" y="6799320"/>
            <a:ext cx="0" cy="257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"/>
          <p:cNvSpPr/>
          <p:nvPr/>
        </p:nvSpPr>
        <p:spPr>
          <a:xfrm>
            <a:off x="2509920" y="4991040"/>
            <a:ext cx="0" cy="257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"/>
          <p:cNvSpPr/>
          <p:nvPr/>
        </p:nvSpPr>
        <p:spPr>
          <a:xfrm>
            <a:off x="2514600" y="5506920"/>
            <a:ext cx="0" cy="344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"/>
          <p:cNvSpPr/>
          <p:nvPr/>
        </p:nvSpPr>
        <p:spPr>
          <a:xfrm flipV="1">
            <a:off x="2550960" y="6109920"/>
            <a:ext cx="0" cy="258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"/>
          <p:cNvSpPr/>
          <p:nvPr/>
        </p:nvSpPr>
        <p:spPr>
          <a:xfrm>
            <a:off x="2617920" y="5162400"/>
            <a:ext cx="0" cy="516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"/>
          <p:cNvSpPr/>
          <p:nvPr/>
        </p:nvSpPr>
        <p:spPr>
          <a:xfrm flipV="1">
            <a:off x="2617920" y="5162400"/>
            <a:ext cx="0" cy="516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"/>
          <p:cNvSpPr/>
          <p:nvPr/>
        </p:nvSpPr>
        <p:spPr>
          <a:xfrm>
            <a:off x="2652840" y="6195960"/>
            <a:ext cx="0" cy="43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"/>
          <p:cNvSpPr/>
          <p:nvPr/>
        </p:nvSpPr>
        <p:spPr>
          <a:xfrm flipV="1">
            <a:off x="2741760" y="6540120"/>
            <a:ext cx="0" cy="344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"/>
          <p:cNvSpPr/>
          <p:nvPr/>
        </p:nvSpPr>
        <p:spPr>
          <a:xfrm>
            <a:off x="2803680" y="5334120"/>
            <a:ext cx="0" cy="1379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"/>
          <p:cNvSpPr/>
          <p:nvPr/>
        </p:nvSpPr>
        <p:spPr>
          <a:xfrm>
            <a:off x="2741760" y="6540480"/>
            <a:ext cx="0" cy="344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"/>
          <p:cNvSpPr/>
          <p:nvPr/>
        </p:nvSpPr>
        <p:spPr>
          <a:xfrm flipV="1">
            <a:off x="2803680" y="5334120"/>
            <a:ext cx="0" cy="1379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"/>
          <p:cNvSpPr/>
          <p:nvPr/>
        </p:nvSpPr>
        <p:spPr>
          <a:xfrm>
            <a:off x="1085760" y="7400880"/>
            <a:ext cx="1293840" cy="517680"/>
          </a:xfrm>
          <a:custGeom>
            <a:avLst/>
            <a:gdLst/>
            <a:ahLst/>
            <a:rect l="l" t="t" r="r" b="b"/>
            <a:pathLst>
              <a:path w="2879" h="1152">
                <a:moveTo>
                  <a:pt x="0" y="1152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1152"/>
                </a:lnTo>
                <a:lnTo>
                  <a:pt x="2879" y="1152"/>
                </a:lnTo>
                <a:lnTo>
                  <a:pt x="0" y="1152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"/>
          <p:cNvSpPr/>
          <p:nvPr/>
        </p:nvSpPr>
        <p:spPr>
          <a:xfrm>
            <a:off x="1731960" y="7400880"/>
            <a:ext cx="0" cy="201600"/>
          </a:xfrm>
          <a:prstGeom prst="line">
            <a:avLst/>
          </a:prstGeom>
          <a:ln w="9360">
            <a:solidFill>
              <a:srgbClr val="8d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"/>
          <p:cNvSpPr/>
          <p:nvPr/>
        </p:nvSpPr>
        <p:spPr>
          <a:xfrm>
            <a:off x="1473120" y="7400880"/>
            <a:ext cx="0" cy="201600"/>
          </a:xfrm>
          <a:prstGeom prst="line">
            <a:avLst/>
          </a:prstGeom>
          <a:ln w="9360">
            <a:solidFill>
              <a:srgbClr val="8de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"/>
          <p:cNvSpPr/>
          <p:nvPr/>
        </p:nvSpPr>
        <p:spPr>
          <a:xfrm>
            <a:off x="1214280" y="7400880"/>
            <a:ext cx="0" cy="331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"/>
          <p:cNvSpPr/>
          <p:nvPr/>
        </p:nvSpPr>
        <p:spPr>
          <a:xfrm>
            <a:off x="1990800" y="7400880"/>
            <a:ext cx="0" cy="22860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"/>
          <p:cNvSpPr/>
          <p:nvPr/>
        </p:nvSpPr>
        <p:spPr>
          <a:xfrm>
            <a:off x="2251080" y="7400880"/>
            <a:ext cx="0" cy="228600"/>
          </a:xfrm>
          <a:prstGeom prst="line">
            <a:avLst/>
          </a:prstGeom>
          <a:ln w="9360">
            <a:solidFill>
              <a:srgbClr val="e6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"/>
          <p:cNvSpPr/>
          <p:nvPr/>
        </p:nvSpPr>
        <p:spPr>
          <a:xfrm>
            <a:off x="1603440" y="7602480"/>
            <a:ext cx="0" cy="130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"/>
          <p:cNvSpPr/>
          <p:nvPr/>
        </p:nvSpPr>
        <p:spPr>
          <a:xfrm>
            <a:off x="2120760" y="7629480"/>
            <a:ext cx="0" cy="265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"/>
          <p:cNvSpPr/>
          <p:nvPr/>
        </p:nvSpPr>
        <p:spPr>
          <a:xfrm>
            <a:off x="1344600" y="7732800"/>
            <a:ext cx="0" cy="162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"/>
          <p:cNvSpPr/>
          <p:nvPr/>
        </p:nvSpPr>
        <p:spPr>
          <a:xfrm>
            <a:off x="1862280" y="7894800"/>
            <a:ext cx="0" cy="23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"/>
          <p:cNvSpPr/>
          <p:nvPr/>
        </p:nvSpPr>
        <p:spPr>
          <a:xfrm flipH="1">
            <a:off x="1472760" y="7602480"/>
            <a:ext cx="258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"/>
          <p:cNvSpPr/>
          <p:nvPr/>
        </p:nvSpPr>
        <p:spPr>
          <a:xfrm>
            <a:off x="1473120" y="7602480"/>
            <a:ext cx="258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"/>
          <p:cNvSpPr/>
          <p:nvPr/>
        </p:nvSpPr>
        <p:spPr>
          <a:xfrm>
            <a:off x="1214280" y="7732800"/>
            <a:ext cx="38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"/>
          <p:cNvSpPr/>
          <p:nvPr/>
        </p:nvSpPr>
        <p:spPr>
          <a:xfrm>
            <a:off x="1990800" y="7629480"/>
            <a:ext cx="260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"/>
          <p:cNvSpPr/>
          <p:nvPr/>
        </p:nvSpPr>
        <p:spPr>
          <a:xfrm flipH="1">
            <a:off x="1990440" y="7629480"/>
            <a:ext cx="260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"/>
          <p:cNvSpPr/>
          <p:nvPr/>
        </p:nvSpPr>
        <p:spPr>
          <a:xfrm flipH="1">
            <a:off x="1213920" y="7732800"/>
            <a:ext cx="38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"/>
          <p:cNvSpPr/>
          <p:nvPr/>
        </p:nvSpPr>
        <p:spPr>
          <a:xfrm flipH="1">
            <a:off x="1344600" y="7894800"/>
            <a:ext cx="776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"/>
          <p:cNvSpPr/>
          <p:nvPr/>
        </p:nvSpPr>
        <p:spPr>
          <a:xfrm>
            <a:off x="1344600" y="7894800"/>
            <a:ext cx="776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"/>
          <p:cNvSpPr/>
          <p:nvPr/>
        </p:nvSpPr>
        <p:spPr>
          <a:xfrm>
            <a:off x="1085760" y="4818240"/>
            <a:ext cx="1293840" cy="258264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"/>
          <p:cNvSpPr/>
          <p:nvPr/>
        </p:nvSpPr>
        <p:spPr>
          <a:xfrm>
            <a:off x="624240" y="4859280"/>
            <a:ext cx="15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ps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"/>
          <p:cNvSpPr/>
          <p:nvPr/>
        </p:nvSpPr>
        <p:spPr>
          <a:xfrm>
            <a:off x="624960" y="5027760"/>
            <a:ext cx="150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z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"/>
          <p:cNvSpPr/>
          <p:nvPr/>
        </p:nvSpPr>
        <p:spPr>
          <a:xfrm>
            <a:off x="621360" y="5200560"/>
            <a:ext cx="163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p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"/>
          <p:cNvSpPr/>
          <p:nvPr/>
        </p:nvSpPr>
        <p:spPr>
          <a:xfrm>
            <a:off x="622440" y="5375160"/>
            <a:ext cx="210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lyc-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"/>
          <p:cNvSpPr/>
          <p:nvPr/>
        </p:nvSpPr>
        <p:spPr>
          <a:xfrm>
            <a:off x="620640" y="5545080"/>
            <a:ext cx="289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lyc-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"/>
          <p:cNvSpPr/>
          <p:nvPr/>
        </p:nvSpPr>
        <p:spPr>
          <a:xfrm>
            <a:off x="620280" y="5716440"/>
            <a:ext cx="186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cm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"/>
          <p:cNvSpPr/>
          <p:nvPr/>
        </p:nvSpPr>
        <p:spPr>
          <a:xfrm>
            <a:off x="623520" y="5888160"/>
            <a:ext cx="153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dx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"/>
          <p:cNvSpPr/>
          <p:nvPr/>
        </p:nvSpPr>
        <p:spPr>
          <a:xfrm>
            <a:off x="614160" y="6059520"/>
            <a:ext cx="160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hd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"/>
          <p:cNvSpPr/>
          <p:nvPr/>
        </p:nvSpPr>
        <p:spPr>
          <a:xfrm>
            <a:off x="620640" y="6227640"/>
            <a:ext cx="360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chy-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"/>
          <p:cNvSpPr/>
          <p:nvPr/>
        </p:nvSpPr>
        <p:spPr>
          <a:xfrm>
            <a:off x="624960" y="640404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ze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"/>
          <p:cNvSpPr/>
          <p:nvPr/>
        </p:nvSpPr>
        <p:spPr>
          <a:xfrm>
            <a:off x="624240" y="6576840"/>
            <a:ext cx="27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nced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"/>
          <p:cNvSpPr/>
          <p:nvPr/>
        </p:nvSpPr>
        <p:spPr>
          <a:xfrm>
            <a:off x="624240" y="6746760"/>
            <a:ext cx="27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nce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"/>
          <p:cNvSpPr/>
          <p:nvPr/>
        </p:nvSpPr>
        <p:spPr>
          <a:xfrm>
            <a:off x="624600" y="6919920"/>
            <a:ext cx="208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cc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"/>
          <p:cNvSpPr/>
          <p:nvPr/>
        </p:nvSpPr>
        <p:spPr>
          <a:xfrm>
            <a:off x="620640" y="7091280"/>
            <a:ext cx="360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chy-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"/>
          <p:cNvSpPr/>
          <p:nvPr/>
        </p:nvSpPr>
        <p:spPr>
          <a:xfrm>
            <a:off x="620640" y="7261200"/>
            <a:ext cx="216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cc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"/>
          <p:cNvSpPr/>
          <p:nvPr/>
        </p:nvSpPr>
        <p:spPr>
          <a:xfrm>
            <a:off x="1085760" y="4818240"/>
            <a:ext cx="1293840" cy="2582640"/>
          </a:xfrm>
          <a:custGeom>
            <a:avLst/>
            <a:gdLst/>
            <a:ahLst/>
            <a:rect l="l" t="t" r="r" b="b"/>
            <a:pathLst>
              <a:path w="2879" h="5760">
                <a:moveTo>
                  <a:pt x="0" y="5760"/>
                </a:moveTo>
                <a:lnTo>
                  <a:pt x="0" y="0"/>
                </a:lnTo>
                <a:lnTo>
                  <a:pt x="0" y="0"/>
                </a:lnTo>
                <a:lnTo>
                  <a:pt x="2879" y="0"/>
                </a:lnTo>
                <a:lnTo>
                  <a:pt x="2879" y="0"/>
                </a:lnTo>
                <a:lnTo>
                  <a:pt x="2879" y="5760"/>
                </a:lnTo>
                <a:lnTo>
                  <a:pt x="2879" y="5760"/>
                </a:lnTo>
                <a:lnTo>
                  <a:pt x="0" y="576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"/>
          <p:cNvSpPr/>
          <p:nvPr/>
        </p:nvSpPr>
        <p:spPr>
          <a:xfrm>
            <a:off x="1129680" y="46450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"/>
          <p:cNvSpPr/>
          <p:nvPr/>
        </p:nvSpPr>
        <p:spPr>
          <a:xfrm>
            <a:off x="1388160" y="46450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"/>
          <p:cNvSpPr/>
          <p:nvPr/>
        </p:nvSpPr>
        <p:spPr>
          <a:xfrm>
            <a:off x="1637640" y="46450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"/>
          <p:cNvSpPr/>
          <p:nvPr/>
        </p:nvSpPr>
        <p:spPr>
          <a:xfrm>
            <a:off x="1909440" y="4645080"/>
            <a:ext cx="162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B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"/>
          <p:cNvSpPr/>
          <p:nvPr/>
        </p:nvSpPr>
        <p:spPr>
          <a:xfrm>
            <a:off x="2164680" y="46450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Times New Roman"/>
              </a:rPr>
              <a:t>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10T10:32:51Z</dcterms:created>
  <dc:creator>Federica</dc:creator>
  <dc:description/>
  <dc:language>en-US</dc:language>
  <cp:lastModifiedBy>CR</cp:lastModifiedBy>
  <dcterms:modified xsi:type="dcterms:W3CDTF">2011-01-20T15:19:34Z</dcterms:modified>
  <cp:revision>147</cp:revision>
  <dc:subject/>
  <dc:title>Diapositiva 1</dc:title>
</cp:coreProperties>
</file>